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9" r:id="rId2"/>
  </p:sldIdLst>
  <p:sldSz cx="2970213" cy="1601788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15608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7F8B1FC-0175-4D23-9474-169828BE1CFF}" v="15" dt="2024-11-27T01:01:14.30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7620" autoAdjust="0"/>
    <p:restoredTop sz="92504" autoAdjust="0"/>
  </p:normalViewPr>
  <p:slideViewPr>
    <p:cSldViewPr snapToGrid="0">
      <p:cViewPr varScale="1">
        <p:scale>
          <a:sx n="400" d="100"/>
          <a:sy n="400" d="100"/>
        </p:scale>
        <p:origin x="3356" y="13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이용인" userId="f23b8f65-dda2-4781-a16d-16fe7c5f2390" providerId="ADAL" clId="{27F8B1FC-0175-4D23-9474-169828BE1CFF}"/>
    <pc:docChg chg="undo custSel addSld delSld modSld modMainMaster modNotesMaster">
      <pc:chgData name="이용인" userId="f23b8f65-dda2-4781-a16d-16fe7c5f2390" providerId="ADAL" clId="{27F8B1FC-0175-4D23-9474-169828BE1CFF}" dt="2024-11-27T01:01:21.027" v="36" actId="47"/>
      <pc:docMkLst>
        <pc:docMk/>
      </pc:docMkLst>
      <pc:sldChg chg="modSp del mod modNotes">
        <pc:chgData name="이용인" userId="f23b8f65-dda2-4781-a16d-16fe7c5f2390" providerId="ADAL" clId="{27F8B1FC-0175-4D23-9474-169828BE1CFF}" dt="2024-11-27T01:01:21.027" v="36" actId="47"/>
        <pc:sldMkLst>
          <pc:docMk/>
          <pc:sldMk cId="600729080" sldId="258"/>
        </pc:sldMkLst>
        <pc:spChg chg="mod">
          <ac:chgData name="이용인" userId="f23b8f65-dda2-4781-a16d-16fe7c5f2390" providerId="ADAL" clId="{27F8B1FC-0175-4D23-9474-169828BE1CFF}" dt="2024-11-27T01:01:02.004" v="22"/>
          <ac:spMkLst>
            <pc:docMk/>
            <pc:sldMk cId="600729080" sldId="258"/>
            <ac:spMk id="4" creationId="{B3A52E52-DBCF-05BE-7A32-8B6A731C5C73}"/>
          </ac:spMkLst>
        </pc:spChg>
        <pc:spChg chg="mod">
          <ac:chgData name="이용인" userId="f23b8f65-dda2-4781-a16d-16fe7c5f2390" providerId="ADAL" clId="{27F8B1FC-0175-4D23-9474-169828BE1CFF}" dt="2024-11-27T01:01:02.004" v="22"/>
          <ac:spMkLst>
            <pc:docMk/>
            <pc:sldMk cId="600729080" sldId="258"/>
            <ac:spMk id="8" creationId="{2932881B-A1F2-6D93-D7F4-4371AB5E51BA}"/>
          </ac:spMkLst>
        </pc:spChg>
        <pc:spChg chg="mod">
          <ac:chgData name="이용인" userId="f23b8f65-dda2-4781-a16d-16fe7c5f2390" providerId="ADAL" clId="{27F8B1FC-0175-4D23-9474-169828BE1CFF}" dt="2024-11-27T01:01:02.004" v="22"/>
          <ac:spMkLst>
            <pc:docMk/>
            <pc:sldMk cId="600729080" sldId="258"/>
            <ac:spMk id="9" creationId="{CD41ABCD-F63A-5854-EA9A-BBB1137F50CF}"/>
          </ac:spMkLst>
        </pc:spChg>
        <pc:spChg chg="mod">
          <ac:chgData name="이용인" userId="f23b8f65-dda2-4781-a16d-16fe7c5f2390" providerId="ADAL" clId="{27F8B1FC-0175-4D23-9474-169828BE1CFF}" dt="2024-11-27T01:01:02.004" v="22"/>
          <ac:spMkLst>
            <pc:docMk/>
            <pc:sldMk cId="600729080" sldId="258"/>
            <ac:spMk id="10" creationId="{E0095364-8454-716A-26E6-70138C6CA7E9}"/>
          </ac:spMkLst>
        </pc:spChg>
        <pc:spChg chg="mod">
          <ac:chgData name="이용인" userId="f23b8f65-dda2-4781-a16d-16fe7c5f2390" providerId="ADAL" clId="{27F8B1FC-0175-4D23-9474-169828BE1CFF}" dt="2024-11-27T01:01:02.004" v="22"/>
          <ac:spMkLst>
            <pc:docMk/>
            <pc:sldMk cId="600729080" sldId="258"/>
            <ac:spMk id="13" creationId="{16094A3A-B178-E646-3E94-370FE14BD7C5}"/>
          </ac:spMkLst>
        </pc:spChg>
        <pc:spChg chg="mod">
          <ac:chgData name="이용인" userId="f23b8f65-dda2-4781-a16d-16fe7c5f2390" providerId="ADAL" clId="{27F8B1FC-0175-4D23-9474-169828BE1CFF}" dt="2024-11-27T01:01:02.004" v="22"/>
          <ac:spMkLst>
            <pc:docMk/>
            <pc:sldMk cId="600729080" sldId="258"/>
            <ac:spMk id="16" creationId="{AD05F6A7-A8A7-51A4-DD13-2F0CDE5B977E}"/>
          </ac:spMkLst>
        </pc:spChg>
        <pc:spChg chg="mod">
          <ac:chgData name="이용인" userId="f23b8f65-dda2-4781-a16d-16fe7c5f2390" providerId="ADAL" clId="{27F8B1FC-0175-4D23-9474-169828BE1CFF}" dt="2024-11-27T01:01:02.004" v="22"/>
          <ac:spMkLst>
            <pc:docMk/>
            <pc:sldMk cId="600729080" sldId="258"/>
            <ac:spMk id="17" creationId="{0259D49D-C92C-4C29-A638-D83C0E21093C}"/>
          </ac:spMkLst>
        </pc:spChg>
        <pc:spChg chg="mod">
          <ac:chgData name="이용인" userId="f23b8f65-dda2-4781-a16d-16fe7c5f2390" providerId="ADAL" clId="{27F8B1FC-0175-4D23-9474-169828BE1CFF}" dt="2024-11-27T01:01:02.004" v="22"/>
          <ac:spMkLst>
            <pc:docMk/>
            <pc:sldMk cId="600729080" sldId="258"/>
            <ac:spMk id="21" creationId="{EB4158E1-A675-A5EF-2FE4-C36F212817D5}"/>
          </ac:spMkLst>
        </pc:spChg>
        <pc:spChg chg="mod">
          <ac:chgData name="이용인" userId="f23b8f65-dda2-4781-a16d-16fe7c5f2390" providerId="ADAL" clId="{27F8B1FC-0175-4D23-9474-169828BE1CFF}" dt="2024-11-27T01:01:02.004" v="22"/>
          <ac:spMkLst>
            <pc:docMk/>
            <pc:sldMk cId="600729080" sldId="258"/>
            <ac:spMk id="23" creationId="{66542293-6D5C-14AA-8460-6C3865DD17F3}"/>
          </ac:spMkLst>
        </pc:spChg>
        <pc:spChg chg="mod">
          <ac:chgData name="이용인" userId="f23b8f65-dda2-4781-a16d-16fe7c5f2390" providerId="ADAL" clId="{27F8B1FC-0175-4D23-9474-169828BE1CFF}" dt="2024-11-27T01:01:02.004" v="22"/>
          <ac:spMkLst>
            <pc:docMk/>
            <pc:sldMk cId="600729080" sldId="258"/>
            <ac:spMk id="25" creationId="{D21E29B3-0FC3-D33D-E9CE-3D0A5F33BB26}"/>
          </ac:spMkLst>
        </pc:spChg>
        <pc:spChg chg="mod">
          <ac:chgData name="이용인" userId="f23b8f65-dda2-4781-a16d-16fe7c5f2390" providerId="ADAL" clId="{27F8B1FC-0175-4D23-9474-169828BE1CFF}" dt="2024-11-27T01:01:02.004" v="22"/>
          <ac:spMkLst>
            <pc:docMk/>
            <pc:sldMk cId="600729080" sldId="258"/>
            <ac:spMk id="27" creationId="{F76BEE88-FD9D-203D-C642-064BE0AE20D8}"/>
          </ac:spMkLst>
        </pc:spChg>
        <pc:spChg chg="mod">
          <ac:chgData name="이용인" userId="f23b8f65-dda2-4781-a16d-16fe7c5f2390" providerId="ADAL" clId="{27F8B1FC-0175-4D23-9474-169828BE1CFF}" dt="2024-11-27T01:01:02.004" v="22"/>
          <ac:spMkLst>
            <pc:docMk/>
            <pc:sldMk cId="600729080" sldId="258"/>
            <ac:spMk id="28" creationId="{B56F4E32-EDF4-2D1A-0820-AE989E3C4F84}"/>
          </ac:spMkLst>
        </pc:spChg>
        <pc:spChg chg="mod">
          <ac:chgData name="이용인" userId="f23b8f65-dda2-4781-a16d-16fe7c5f2390" providerId="ADAL" clId="{27F8B1FC-0175-4D23-9474-169828BE1CFF}" dt="2024-11-27T01:01:02.004" v="22"/>
          <ac:spMkLst>
            <pc:docMk/>
            <pc:sldMk cId="600729080" sldId="258"/>
            <ac:spMk id="30" creationId="{6E0CA314-E64B-0A79-DC4A-5F0CD5156A8F}"/>
          </ac:spMkLst>
        </pc:spChg>
        <pc:spChg chg="mod">
          <ac:chgData name="이용인" userId="f23b8f65-dda2-4781-a16d-16fe7c5f2390" providerId="ADAL" clId="{27F8B1FC-0175-4D23-9474-169828BE1CFF}" dt="2024-11-27T01:01:02.004" v="22"/>
          <ac:spMkLst>
            <pc:docMk/>
            <pc:sldMk cId="600729080" sldId="258"/>
            <ac:spMk id="31" creationId="{D1A72EB7-21B8-3E72-C62E-D56223E7C6F4}"/>
          </ac:spMkLst>
        </pc:spChg>
        <pc:spChg chg="mod">
          <ac:chgData name="이용인" userId="f23b8f65-dda2-4781-a16d-16fe7c5f2390" providerId="ADAL" clId="{27F8B1FC-0175-4D23-9474-169828BE1CFF}" dt="2024-11-27T01:01:02.004" v="22"/>
          <ac:spMkLst>
            <pc:docMk/>
            <pc:sldMk cId="600729080" sldId="258"/>
            <ac:spMk id="39" creationId="{9F8D601C-3CA8-A81C-540F-ACF74F3B88E3}"/>
          </ac:spMkLst>
        </pc:spChg>
        <pc:spChg chg="mod">
          <ac:chgData name="이용인" userId="f23b8f65-dda2-4781-a16d-16fe7c5f2390" providerId="ADAL" clId="{27F8B1FC-0175-4D23-9474-169828BE1CFF}" dt="2024-11-27T01:01:02.004" v="22"/>
          <ac:spMkLst>
            <pc:docMk/>
            <pc:sldMk cId="600729080" sldId="258"/>
            <ac:spMk id="41" creationId="{9C686722-B63B-51F8-1073-91D18FB09B0D}"/>
          </ac:spMkLst>
        </pc:spChg>
        <pc:spChg chg="mod">
          <ac:chgData name="이용인" userId="f23b8f65-dda2-4781-a16d-16fe7c5f2390" providerId="ADAL" clId="{27F8B1FC-0175-4D23-9474-169828BE1CFF}" dt="2024-11-27T01:01:02.004" v="22"/>
          <ac:spMkLst>
            <pc:docMk/>
            <pc:sldMk cId="600729080" sldId="258"/>
            <ac:spMk id="42" creationId="{FAC2D2DB-5C42-3CDC-11D0-3A3E7B84F17A}"/>
          </ac:spMkLst>
        </pc:spChg>
        <pc:spChg chg="mod">
          <ac:chgData name="이용인" userId="f23b8f65-dda2-4781-a16d-16fe7c5f2390" providerId="ADAL" clId="{27F8B1FC-0175-4D23-9474-169828BE1CFF}" dt="2024-11-27T01:01:02.004" v="22"/>
          <ac:spMkLst>
            <pc:docMk/>
            <pc:sldMk cId="600729080" sldId="258"/>
            <ac:spMk id="43" creationId="{9AA62230-9928-0C37-2706-E3BE8361780B}"/>
          </ac:spMkLst>
        </pc:spChg>
        <pc:grpChg chg="mod">
          <ac:chgData name="이용인" userId="f23b8f65-dda2-4781-a16d-16fe7c5f2390" providerId="ADAL" clId="{27F8B1FC-0175-4D23-9474-169828BE1CFF}" dt="2024-11-27T01:01:02.004" v="22"/>
          <ac:grpSpMkLst>
            <pc:docMk/>
            <pc:sldMk cId="600729080" sldId="258"/>
            <ac:grpSpMk id="2" creationId="{5DC5940B-B87F-97E6-29AB-57EB99DC73C5}"/>
          </ac:grpSpMkLst>
        </pc:grpChg>
        <pc:grpChg chg="mod">
          <ac:chgData name="이용인" userId="f23b8f65-dda2-4781-a16d-16fe7c5f2390" providerId="ADAL" clId="{27F8B1FC-0175-4D23-9474-169828BE1CFF}" dt="2024-11-27T01:01:02.004" v="22"/>
          <ac:grpSpMkLst>
            <pc:docMk/>
            <pc:sldMk cId="600729080" sldId="258"/>
            <ac:grpSpMk id="3" creationId="{2DF9DD4E-EE69-03E3-C4C8-C0F4BF21270F}"/>
          </ac:grpSpMkLst>
        </pc:grpChg>
        <pc:grpChg chg="mod">
          <ac:chgData name="이용인" userId="f23b8f65-dda2-4781-a16d-16fe7c5f2390" providerId="ADAL" clId="{27F8B1FC-0175-4D23-9474-169828BE1CFF}" dt="2024-11-27T01:01:02.004" v="22"/>
          <ac:grpSpMkLst>
            <pc:docMk/>
            <pc:sldMk cId="600729080" sldId="258"/>
            <ac:grpSpMk id="5" creationId="{B8FE6BC0-1B6E-F503-34B5-7D2EAFC2952E}"/>
          </ac:grpSpMkLst>
        </pc:grpChg>
        <pc:grpChg chg="mod">
          <ac:chgData name="이용인" userId="f23b8f65-dda2-4781-a16d-16fe7c5f2390" providerId="ADAL" clId="{27F8B1FC-0175-4D23-9474-169828BE1CFF}" dt="2024-11-27T01:01:02.004" v="22"/>
          <ac:grpSpMkLst>
            <pc:docMk/>
            <pc:sldMk cId="600729080" sldId="258"/>
            <ac:grpSpMk id="7" creationId="{828E669F-25C9-1F23-D5BB-F2E1ECA139EC}"/>
          </ac:grpSpMkLst>
        </pc:grpChg>
        <pc:grpChg chg="mod">
          <ac:chgData name="이용인" userId="f23b8f65-dda2-4781-a16d-16fe7c5f2390" providerId="ADAL" clId="{27F8B1FC-0175-4D23-9474-169828BE1CFF}" dt="2024-11-27T01:01:02.004" v="22"/>
          <ac:grpSpMkLst>
            <pc:docMk/>
            <pc:sldMk cId="600729080" sldId="258"/>
            <ac:grpSpMk id="11" creationId="{48A2761D-1207-64C9-3A81-9967F4271CA4}"/>
          </ac:grpSpMkLst>
        </pc:grpChg>
        <pc:grpChg chg="mod">
          <ac:chgData name="이용인" userId="f23b8f65-dda2-4781-a16d-16fe7c5f2390" providerId="ADAL" clId="{27F8B1FC-0175-4D23-9474-169828BE1CFF}" dt="2024-11-27T01:01:02.004" v="22"/>
          <ac:grpSpMkLst>
            <pc:docMk/>
            <pc:sldMk cId="600729080" sldId="258"/>
            <ac:grpSpMk id="14" creationId="{96E9DC94-529D-54D0-1C3C-674AD5E2F5CF}"/>
          </ac:grpSpMkLst>
        </pc:grpChg>
        <pc:grpChg chg="mod">
          <ac:chgData name="이용인" userId="f23b8f65-dda2-4781-a16d-16fe7c5f2390" providerId="ADAL" clId="{27F8B1FC-0175-4D23-9474-169828BE1CFF}" dt="2024-11-27T01:01:02.004" v="22"/>
          <ac:grpSpMkLst>
            <pc:docMk/>
            <pc:sldMk cId="600729080" sldId="258"/>
            <ac:grpSpMk id="34" creationId="{39E601C9-2C5E-8CCB-F8C2-B3681CD829BF}"/>
          </ac:grpSpMkLst>
        </pc:grpChg>
        <pc:grpChg chg="mod">
          <ac:chgData name="이용인" userId="f23b8f65-dda2-4781-a16d-16fe7c5f2390" providerId="ADAL" clId="{27F8B1FC-0175-4D23-9474-169828BE1CFF}" dt="2024-11-27T01:01:02.004" v="22"/>
          <ac:grpSpMkLst>
            <pc:docMk/>
            <pc:sldMk cId="600729080" sldId="258"/>
            <ac:grpSpMk id="35" creationId="{A4D9E308-6EF6-8C06-AC14-B87790F88999}"/>
          </ac:grpSpMkLst>
        </pc:grpChg>
        <pc:grpChg chg="mod">
          <ac:chgData name="이용인" userId="f23b8f65-dda2-4781-a16d-16fe7c5f2390" providerId="ADAL" clId="{27F8B1FC-0175-4D23-9474-169828BE1CFF}" dt="2024-11-27T01:01:02.004" v="22"/>
          <ac:grpSpMkLst>
            <pc:docMk/>
            <pc:sldMk cId="600729080" sldId="258"/>
            <ac:grpSpMk id="36" creationId="{6D30FAF0-50FB-C563-6A03-F93C12BA61D9}"/>
          </ac:grpSpMkLst>
        </pc:grpChg>
        <pc:grpChg chg="mod">
          <ac:chgData name="이용인" userId="f23b8f65-dda2-4781-a16d-16fe7c5f2390" providerId="ADAL" clId="{27F8B1FC-0175-4D23-9474-169828BE1CFF}" dt="2024-11-27T01:01:02.004" v="22"/>
          <ac:grpSpMkLst>
            <pc:docMk/>
            <pc:sldMk cId="600729080" sldId="258"/>
            <ac:grpSpMk id="37" creationId="{F8D10628-3B81-C994-4F95-C750C49C063E}"/>
          </ac:grpSpMkLst>
        </pc:grpChg>
        <pc:grpChg chg="mod">
          <ac:chgData name="이용인" userId="f23b8f65-dda2-4781-a16d-16fe7c5f2390" providerId="ADAL" clId="{27F8B1FC-0175-4D23-9474-169828BE1CFF}" dt="2024-11-27T01:01:02.004" v="22"/>
          <ac:grpSpMkLst>
            <pc:docMk/>
            <pc:sldMk cId="600729080" sldId="258"/>
            <ac:grpSpMk id="54" creationId="{6282A531-9B89-B728-AAE1-B5EA36636D9D}"/>
          </ac:grpSpMkLst>
        </pc:grpChg>
        <pc:picChg chg="mod">
          <ac:chgData name="이용인" userId="f23b8f65-dda2-4781-a16d-16fe7c5f2390" providerId="ADAL" clId="{27F8B1FC-0175-4D23-9474-169828BE1CFF}" dt="2024-11-27T01:01:02.004" v="22"/>
          <ac:picMkLst>
            <pc:docMk/>
            <pc:sldMk cId="600729080" sldId="258"/>
            <ac:picMk id="12" creationId="{330C9E5C-F982-820D-537B-5FA402BC6E99}"/>
          </ac:picMkLst>
        </pc:picChg>
        <pc:picChg chg="mod">
          <ac:chgData name="이용인" userId="f23b8f65-dda2-4781-a16d-16fe7c5f2390" providerId="ADAL" clId="{27F8B1FC-0175-4D23-9474-169828BE1CFF}" dt="2024-11-27T01:01:02.004" v="22"/>
          <ac:picMkLst>
            <pc:docMk/>
            <pc:sldMk cId="600729080" sldId="258"/>
            <ac:picMk id="15" creationId="{4A9BD996-8FE4-F918-0E3F-8651AF161FEF}"/>
          </ac:picMkLst>
        </pc:picChg>
        <pc:picChg chg="mod">
          <ac:chgData name="이용인" userId="f23b8f65-dda2-4781-a16d-16fe7c5f2390" providerId="ADAL" clId="{27F8B1FC-0175-4D23-9474-169828BE1CFF}" dt="2024-11-27T01:01:02.004" v="22"/>
          <ac:picMkLst>
            <pc:docMk/>
            <pc:sldMk cId="600729080" sldId="258"/>
            <ac:picMk id="18" creationId="{4451393D-D2DD-5C19-2A7E-EB7521634602}"/>
          </ac:picMkLst>
        </pc:picChg>
        <pc:picChg chg="mod">
          <ac:chgData name="이용인" userId="f23b8f65-dda2-4781-a16d-16fe7c5f2390" providerId="ADAL" clId="{27F8B1FC-0175-4D23-9474-169828BE1CFF}" dt="2024-11-27T01:01:02.004" v="22"/>
          <ac:picMkLst>
            <pc:docMk/>
            <pc:sldMk cId="600729080" sldId="258"/>
            <ac:picMk id="22" creationId="{847A9123-1553-812C-F03E-32427AF76944}"/>
          </ac:picMkLst>
        </pc:picChg>
        <pc:picChg chg="mod">
          <ac:chgData name="이용인" userId="f23b8f65-dda2-4781-a16d-16fe7c5f2390" providerId="ADAL" clId="{27F8B1FC-0175-4D23-9474-169828BE1CFF}" dt="2024-11-27T01:01:02.004" v="22"/>
          <ac:picMkLst>
            <pc:docMk/>
            <pc:sldMk cId="600729080" sldId="258"/>
            <ac:picMk id="24" creationId="{1F886DAB-92CB-0B02-1FB6-F0793E45E3C4}"/>
          </ac:picMkLst>
        </pc:picChg>
        <pc:picChg chg="mod">
          <ac:chgData name="이용인" userId="f23b8f65-dda2-4781-a16d-16fe7c5f2390" providerId="ADAL" clId="{27F8B1FC-0175-4D23-9474-169828BE1CFF}" dt="2024-11-27T01:01:02.004" v="22"/>
          <ac:picMkLst>
            <pc:docMk/>
            <pc:sldMk cId="600729080" sldId="258"/>
            <ac:picMk id="26" creationId="{992DC411-C493-39E8-DE01-2B98D0551C6D}"/>
          </ac:picMkLst>
        </pc:picChg>
        <pc:picChg chg="mod">
          <ac:chgData name="이용인" userId="f23b8f65-dda2-4781-a16d-16fe7c5f2390" providerId="ADAL" clId="{27F8B1FC-0175-4D23-9474-169828BE1CFF}" dt="2024-11-27T01:01:02.004" v="22"/>
          <ac:picMkLst>
            <pc:docMk/>
            <pc:sldMk cId="600729080" sldId="258"/>
            <ac:picMk id="29" creationId="{3BDF95AA-C9F3-C450-3CE8-D8D8C54BF557}"/>
          </ac:picMkLst>
        </pc:picChg>
      </pc:sldChg>
      <pc:sldChg chg="new del">
        <pc:chgData name="이용인" userId="f23b8f65-dda2-4781-a16d-16fe7c5f2390" providerId="ADAL" clId="{27F8B1FC-0175-4D23-9474-169828BE1CFF}" dt="2024-11-27T00:57:54.605" v="6" actId="680"/>
        <pc:sldMkLst>
          <pc:docMk/>
          <pc:sldMk cId="668392458" sldId="259"/>
        </pc:sldMkLst>
      </pc:sldChg>
      <pc:sldChg chg="modSp add modNotes">
        <pc:chgData name="이용인" userId="f23b8f65-dda2-4781-a16d-16fe7c5f2390" providerId="ADAL" clId="{27F8B1FC-0175-4D23-9474-169828BE1CFF}" dt="2024-11-27T01:01:14.302" v="35" actId="1035"/>
        <pc:sldMkLst>
          <pc:docMk/>
          <pc:sldMk cId="2372757794" sldId="259"/>
        </pc:sldMkLst>
        <pc:spChg chg="mod">
          <ac:chgData name="이용인" userId="f23b8f65-dda2-4781-a16d-16fe7c5f2390" providerId="ADAL" clId="{27F8B1FC-0175-4D23-9474-169828BE1CFF}" dt="2024-11-27T01:01:14.302" v="35" actId="1035"/>
          <ac:spMkLst>
            <pc:docMk/>
            <pc:sldMk cId="2372757794" sldId="259"/>
            <ac:spMk id="4" creationId="{278A7E18-72C2-B65C-B766-F6CB34CFFB51}"/>
          </ac:spMkLst>
        </pc:spChg>
        <pc:spChg chg="mod">
          <ac:chgData name="이용인" userId="f23b8f65-dda2-4781-a16d-16fe7c5f2390" providerId="ADAL" clId="{27F8B1FC-0175-4D23-9474-169828BE1CFF}" dt="2024-11-27T01:01:14.302" v="35" actId="1035"/>
          <ac:spMkLst>
            <pc:docMk/>
            <pc:sldMk cId="2372757794" sldId="259"/>
            <ac:spMk id="8" creationId="{A05CAF6F-CCCF-48E7-B55C-CD894BE8ED30}"/>
          </ac:spMkLst>
        </pc:spChg>
        <pc:spChg chg="mod">
          <ac:chgData name="이용인" userId="f23b8f65-dda2-4781-a16d-16fe7c5f2390" providerId="ADAL" clId="{27F8B1FC-0175-4D23-9474-169828BE1CFF}" dt="2024-11-27T01:01:14.302" v="35" actId="1035"/>
          <ac:spMkLst>
            <pc:docMk/>
            <pc:sldMk cId="2372757794" sldId="259"/>
            <ac:spMk id="9" creationId="{D20938DC-02E8-EB65-743A-0C43B9D55709}"/>
          </ac:spMkLst>
        </pc:spChg>
        <pc:spChg chg="mod">
          <ac:chgData name="이용인" userId="f23b8f65-dda2-4781-a16d-16fe7c5f2390" providerId="ADAL" clId="{27F8B1FC-0175-4D23-9474-169828BE1CFF}" dt="2024-11-27T01:01:14.302" v="35" actId="1035"/>
          <ac:spMkLst>
            <pc:docMk/>
            <pc:sldMk cId="2372757794" sldId="259"/>
            <ac:spMk id="10" creationId="{7652E946-D50F-CB12-FDD8-B46C9843B709}"/>
          </ac:spMkLst>
        </pc:spChg>
        <pc:spChg chg="mod">
          <ac:chgData name="이용인" userId="f23b8f65-dda2-4781-a16d-16fe7c5f2390" providerId="ADAL" clId="{27F8B1FC-0175-4D23-9474-169828BE1CFF}" dt="2024-11-27T01:01:14.302" v="35" actId="1035"/>
          <ac:spMkLst>
            <pc:docMk/>
            <pc:sldMk cId="2372757794" sldId="259"/>
            <ac:spMk id="13" creationId="{2AF0F58C-28F2-6763-9074-D9AF90DFA356}"/>
          </ac:spMkLst>
        </pc:spChg>
        <pc:spChg chg="mod">
          <ac:chgData name="이용인" userId="f23b8f65-dda2-4781-a16d-16fe7c5f2390" providerId="ADAL" clId="{27F8B1FC-0175-4D23-9474-169828BE1CFF}" dt="2024-11-27T01:01:14.302" v="35" actId="1035"/>
          <ac:spMkLst>
            <pc:docMk/>
            <pc:sldMk cId="2372757794" sldId="259"/>
            <ac:spMk id="16" creationId="{1BEDB21A-198D-AB5A-A337-6C2E007E9E21}"/>
          </ac:spMkLst>
        </pc:spChg>
        <pc:spChg chg="mod">
          <ac:chgData name="이용인" userId="f23b8f65-dda2-4781-a16d-16fe7c5f2390" providerId="ADAL" clId="{27F8B1FC-0175-4D23-9474-169828BE1CFF}" dt="2024-11-27T01:01:14.302" v="35" actId="1035"/>
          <ac:spMkLst>
            <pc:docMk/>
            <pc:sldMk cId="2372757794" sldId="259"/>
            <ac:spMk id="17" creationId="{FD2BCB91-5ED6-AF26-56CE-B04D2F753E3E}"/>
          </ac:spMkLst>
        </pc:spChg>
        <pc:spChg chg="mod">
          <ac:chgData name="이용인" userId="f23b8f65-dda2-4781-a16d-16fe7c5f2390" providerId="ADAL" clId="{27F8B1FC-0175-4D23-9474-169828BE1CFF}" dt="2024-11-27T01:01:14.302" v="35" actId="1035"/>
          <ac:spMkLst>
            <pc:docMk/>
            <pc:sldMk cId="2372757794" sldId="259"/>
            <ac:spMk id="21" creationId="{BFA5CF87-07E9-3FCD-A481-9ECF73BDEB9B}"/>
          </ac:spMkLst>
        </pc:spChg>
        <pc:spChg chg="mod">
          <ac:chgData name="이용인" userId="f23b8f65-dda2-4781-a16d-16fe7c5f2390" providerId="ADAL" clId="{27F8B1FC-0175-4D23-9474-169828BE1CFF}" dt="2024-11-27T01:01:14.302" v="35" actId="1035"/>
          <ac:spMkLst>
            <pc:docMk/>
            <pc:sldMk cId="2372757794" sldId="259"/>
            <ac:spMk id="23" creationId="{E355372A-4FC4-1362-7885-C72344ED2097}"/>
          </ac:spMkLst>
        </pc:spChg>
        <pc:spChg chg="mod">
          <ac:chgData name="이용인" userId="f23b8f65-dda2-4781-a16d-16fe7c5f2390" providerId="ADAL" clId="{27F8B1FC-0175-4D23-9474-169828BE1CFF}" dt="2024-11-27T01:01:14.302" v="35" actId="1035"/>
          <ac:spMkLst>
            <pc:docMk/>
            <pc:sldMk cId="2372757794" sldId="259"/>
            <ac:spMk id="25" creationId="{83E833DB-9E6D-9DE0-E2CE-9CFAFC8A1A83}"/>
          </ac:spMkLst>
        </pc:spChg>
        <pc:spChg chg="mod">
          <ac:chgData name="이용인" userId="f23b8f65-dda2-4781-a16d-16fe7c5f2390" providerId="ADAL" clId="{27F8B1FC-0175-4D23-9474-169828BE1CFF}" dt="2024-11-27T01:01:14.302" v="35" actId="1035"/>
          <ac:spMkLst>
            <pc:docMk/>
            <pc:sldMk cId="2372757794" sldId="259"/>
            <ac:spMk id="27" creationId="{9D764975-30E8-D2E5-AAFE-AC22A7248FD4}"/>
          </ac:spMkLst>
        </pc:spChg>
        <pc:spChg chg="mod">
          <ac:chgData name="이용인" userId="f23b8f65-dda2-4781-a16d-16fe7c5f2390" providerId="ADAL" clId="{27F8B1FC-0175-4D23-9474-169828BE1CFF}" dt="2024-11-27T01:01:14.302" v="35" actId="1035"/>
          <ac:spMkLst>
            <pc:docMk/>
            <pc:sldMk cId="2372757794" sldId="259"/>
            <ac:spMk id="28" creationId="{33C9FB1F-3466-8E2A-3442-2B50B12DC6A4}"/>
          </ac:spMkLst>
        </pc:spChg>
        <pc:spChg chg="mod">
          <ac:chgData name="이용인" userId="f23b8f65-dda2-4781-a16d-16fe7c5f2390" providerId="ADAL" clId="{27F8B1FC-0175-4D23-9474-169828BE1CFF}" dt="2024-11-27T01:01:14.302" v="35" actId="1035"/>
          <ac:spMkLst>
            <pc:docMk/>
            <pc:sldMk cId="2372757794" sldId="259"/>
            <ac:spMk id="30" creationId="{7F8F8532-F2EC-052E-66C2-FBFC42D3C6D0}"/>
          </ac:spMkLst>
        </pc:spChg>
        <pc:spChg chg="mod">
          <ac:chgData name="이용인" userId="f23b8f65-dda2-4781-a16d-16fe7c5f2390" providerId="ADAL" clId="{27F8B1FC-0175-4D23-9474-169828BE1CFF}" dt="2024-11-27T01:01:14.302" v="35" actId="1035"/>
          <ac:spMkLst>
            <pc:docMk/>
            <pc:sldMk cId="2372757794" sldId="259"/>
            <ac:spMk id="31" creationId="{CF9D4236-B68B-CEF0-A221-9235719D0056}"/>
          </ac:spMkLst>
        </pc:spChg>
        <pc:spChg chg="mod">
          <ac:chgData name="이용인" userId="f23b8f65-dda2-4781-a16d-16fe7c5f2390" providerId="ADAL" clId="{27F8B1FC-0175-4D23-9474-169828BE1CFF}" dt="2024-11-27T01:01:14.302" v="35" actId="1035"/>
          <ac:spMkLst>
            <pc:docMk/>
            <pc:sldMk cId="2372757794" sldId="259"/>
            <ac:spMk id="39" creationId="{CD0C9C68-84E0-5692-DD48-1F8C197FAA9F}"/>
          </ac:spMkLst>
        </pc:spChg>
        <pc:spChg chg="mod">
          <ac:chgData name="이용인" userId="f23b8f65-dda2-4781-a16d-16fe7c5f2390" providerId="ADAL" clId="{27F8B1FC-0175-4D23-9474-169828BE1CFF}" dt="2024-11-27T01:01:14.302" v="35" actId="1035"/>
          <ac:spMkLst>
            <pc:docMk/>
            <pc:sldMk cId="2372757794" sldId="259"/>
            <ac:spMk id="41" creationId="{1C83BD70-EE49-97BA-FCAC-A38E000382F4}"/>
          </ac:spMkLst>
        </pc:spChg>
        <pc:spChg chg="mod">
          <ac:chgData name="이용인" userId="f23b8f65-dda2-4781-a16d-16fe7c5f2390" providerId="ADAL" clId="{27F8B1FC-0175-4D23-9474-169828BE1CFF}" dt="2024-11-27T01:01:14.302" v="35" actId="1035"/>
          <ac:spMkLst>
            <pc:docMk/>
            <pc:sldMk cId="2372757794" sldId="259"/>
            <ac:spMk id="42" creationId="{5F83CD78-F73B-6663-52C7-4938173AE343}"/>
          </ac:spMkLst>
        </pc:spChg>
        <pc:spChg chg="mod">
          <ac:chgData name="이용인" userId="f23b8f65-dda2-4781-a16d-16fe7c5f2390" providerId="ADAL" clId="{27F8B1FC-0175-4D23-9474-169828BE1CFF}" dt="2024-11-27T01:01:14.302" v="35" actId="1035"/>
          <ac:spMkLst>
            <pc:docMk/>
            <pc:sldMk cId="2372757794" sldId="259"/>
            <ac:spMk id="43" creationId="{7E123A14-5B14-927A-1690-4C706EEB9BB9}"/>
          </ac:spMkLst>
        </pc:spChg>
        <pc:grpChg chg="mod">
          <ac:chgData name="이용인" userId="f23b8f65-dda2-4781-a16d-16fe7c5f2390" providerId="ADAL" clId="{27F8B1FC-0175-4D23-9474-169828BE1CFF}" dt="2024-11-27T01:01:14.302" v="35" actId="1035"/>
          <ac:grpSpMkLst>
            <pc:docMk/>
            <pc:sldMk cId="2372757794" sldId="259"/>
            <ac:grpSpMk id="2" creationId="{34F090AC-D946-3CD3-4EF0-50E096568E51}"/>
          </ac:grpSpMkLst>
        </pc:grpChg>
        <pc:grpChg chg="mod">
          <ac:chgData name="이용인" userId="f23b8f65-dda2-4781-a16d-16fe7c5f2390" providerId="ADAL" clId="{27F8B1FC-0175-4D23-9474-169828BE1CFF}" dt="2024-11-27T01:01:14.302" v="35" actId="1035"/>
          <ac:grpSpMkLst>
            <pc:docMk/>
            <pc:sldMk cId="2372757794" sldId="259"/>
            <ac:grpSpMk id="3" creationId="{5ED8D67D-7D12-C0A3-C4DF-69DBF7D0D65D}"/>
          </ac:grpSpMkLst>
        </pc:grpChg>
        <pc:grpChg chg="mod">
          <ac:chgData name="이용인" userId="f23b8f65-dda2-4781-a16d-16fe7c5f2390" providerId="ADAL" clId="{27F8B1FC-0175-4D23-9474-169828BE1CFF}" dt="2024-11-27T01:01:14.302" v="35" actId="1035"/>
          <ac:grpSpMkLst>
            <pc:docMk/>
            <pc:sldMk cId="2372757794" sldId="259"/>
            <ac:grpSpMk id="5" creationId="{17090803-FD37-4778-3166-0061F38D8B84}"/>
          </ac:grpSpMkLst>
        </pc:grpChg>
        <pc:grpChg chg="mod">
          <ac:chgData name="이용인" userId="f23b8f65-dda2-4781-a16d-16fe7c5f2390" providerId="ADAL" clId="{27F8B1FC-0175-4D23-9474-169828BE1CFF}" dt="2024-11-27T01:01:14.302" v="35" actId="1035"/>
          <ac:grpSpMkLst>
            <pc:docMk/>
            <pc:sldMk cId="2372757794" sldId="259"/>
            <ac:grpSpMk id="7" creationId="{2C74588A-E64E-D7FE-C673-2DD7D1FDC352}"/>
          </ac:grpSpMkLst>
        </pc:grpChg>
        <pc:grpChg chg="mod">
          <ac:chgData name="이용인" userId="f23b8f65-dda2-4781-a16d-16fe7c5f2390" providerId="ADAL" clId="{27F8B1FC-0175-4D23-9474-169828BE1CFF}" dt="2024-11-27T01:01:14.302" v="35" actId="1035"/>
          <ac:grpSpMkLst>
            <pc:docMk/>
            <pc:sldMk cId="2372757794" sldId="259"/>
            <ac:grpSpMk id="11" creationId="{CA6925CA-9FB0-1C43-1539-0055BF9C6B27}"/>
          </ac:grpSpMkLst>
        </pc:grpChg>
        <pc:grpChg chg="mod">
          <ac:chgData name="이용인" userId="f23b8f65-dda2-4781-a16d-16fe7c5f2390" providerId="ADAL" clId="{27F8B1FC-0175-4D23-9474-169828BE1CFF}" dt="2024-11-27T01:01:14.302" v="35" actId="1035"/>
          <ac:grpSpMkLst>
            <pc:docMk/>
            <pc:sldMk cId="2372757794" sldId="259"/>
            <ac:grpSpMk id="14" creationId="{277B1270-88BE-68E4-3012-A4C9631C0ED2}"/>
          </ac:grpSpMkLst>
        </pc:grpChg>
        <pc:grpChg chg="mod">
          <ac:chgData name="이용인" userId="f23b8f65-dda2-4781-a16d-16fe7c5f2390" providerId="ADAL" clId="{27F8B1FC-0175-4D23-9474-169828BE1CFF}" dt="2024-11-27T01:01:14.302" v="35" actId="1035"/>
          <ac:grpSpMkLst>
            <pc:docMk/>
            <pc:sldMk cId="2372757794" sldId="259"/>
            <ac:grpSpMk id="34" creationId="{0B018152-84B6-F24A-4EFD-8074C520F139}"/>
          </ac:grpSpMkLst>
        </pc:grpChg>
        <pc:grpChg chg="mod">
          <ac:chgData name="이용인" userId="f23b8f65-dda2-4781-a16d-16fe7c5f2390" providerId="ADAL" clId="{27F8B1FC-0175-4D23-9474-169828BE1CFF}" dt="2024-11-27T01:01:14.302" v="35" actId="1035"/>
          <ac:grpSpMkLst>
            <pc:docMk/>
            <pc:sldMk cId="2372757794" sldId="259"/>
            <ac:grpSpMk id="35" creationId="{AAB9B22E-BB66-719D-34D3-384CBF749121}"/>
          </ac:grpSpMkLst>
        </pc:grpChg>
        <pc:grpChg chg="mod">
          <ac:chgData name="이용인" userId="f23b8f65-dda2-4781-a16d-16fe7c5f2390" providerId="ADAL" clId="{27F8B1FC-0175-4D23-9474-169828BE1CFF}" dt="2024-11-27T01:01:14.302" v="35" actId="1035"/>
          <ac:grpSpMkLst>
            <pc:docMk/>
            <pc:sldMk cId="2372757794" sldId="259"/>
            <ac:grpSpMk id="36" creationId="{66EA0BDF-30AE-70D4-9B9D-BA2B38531297}"/>
          </ac:grpSpMkLst>
        </pc:grpChg>
        <pc:grpChg chg="mod">
          <ac:chgData name="이용인" userId="f23b8f65-dda2-4781-a16d-16fe7c5f2390" providerId="ADAL" clId="{27F8B1FC-0175-4D23-9474-169828BE1CFF}" dt="2024-11-27T01:01:14.302" v="35" actId="1035"/>
          <ac:grpSpMkLst>
            <pc:docMk/>
            <pc:sldMk cId="2372757794" sldId="259"/>
            <ac:grpSpMk id="37" creationId="{E25DD6D0-FE30-9386-56C5-7DBCFFB9FCE0}"/>
          </ac:grpSpMkLst>
        </pc:grpChg>
        <pc:grpChg chg="mod">
          <ac:chgData name="이용인" userId="f23b8f65-dda2-4781-a16d-16fe7c5f2390" providerId="ADAL" clId="{27F8B1FC-0175-4D23-9474-169828BE1CFF}" dt="2024-11-27T01:01:14.302" v="35" actId="1035"/>
          <ac:grpSpMkLst>
            <pc:docMk/>
            <pc:sldMk cId="2372757794" sldId="259"/>
            <ac:grpSpMk id="54" creationId="{4771B00F-4DB0-91D7-1822-814E37A77FC5}"/>
          </ac:grpSpMkLst>
        </pc:grpChg>
        <pc:picChg chg="mod">
          <ac:chgData name="이용인" userId="f23b8f65-dda2-4781-a16d-16fe7c5f2390" providerId="ADAL" clId="{27F8B1FC-0175-4D23-9474-169828BE1CFF}" dt="2024-11-27T01:01:14.302" v="35" actId="1035"/>
          <ac:picMkLst>
            <pc:docMk/>
            <pc:sldMk cId="2372757794" sldId="259"/>
            <ac:picMk id="12" creationId="{920A5376-9D03-44C5-C02B-174BAB711EF7}"/>
          </ac:picMkLst>
        </pc:picChg>
        <pc:picChg chg="mod">
          <ac:chgData name="이용인" userId="f23b8f65-dda2-4781-a16d-16fe7c5f2390" providerId="ADAL" clId="{27F8B1FC-0175-4D23-9474-169828BE1CFF}" dt="2024-11-27T01:01:14.302" v="35" actId="1035"/>
          <ac:picMkLst>
            <pc:docMk/>
            <pc:sldMk cId="2372757794" sldId="259"/>
            <ac:picMk id="15" creationId="{4563EE25-B4C6-9242-5F84-DD8976147804}"/>
          </ac:picMkLst>
        </pc:picChg>
        <pc:picChg chg="mod">
          <ac:chgData name="이용인" userId="f23b8f65-dda2-4781-a16d-16fe7c5f2390" providerId="ADAL" clId="{27F8B1FC-0175-4D23-9474-169828BE1CFF}" dt="2024-11-27T01:01:14.302" v="35" actId="1035"/>
          <ac:picMkLst>
            <pc:docMk/>
            <pc:sldMk cId="2372757794" sldId="259"/>
            <ac:picMk id="18" creationId="{538C2435-4875-9285-4FA8-D81C459B12E3}"/>
          </ac:picMkLst>
        </pc:picChg>
        <pc:picChg chg="mod">
          <ac:chgData name="이용인" userId="f23b8f65-dda2-4781-a16d-16fe7c5f2390" providerId="ADAL" clId="{27F8B1FC-0175-4D23-9474-169828BE1CFF}" dt="2024-11-27T01:01:14.302" v="35" actId="1035"/>
          <ac:picMkLst>
            <pc:docMk/>
            <pc:sldMk cId="2372757794" sldId="259"/>
            <ac:picMk id="22" creationId="{0856FE5C-B91E-D45C-A669-5346D794CB45}"/>
          </ac:picMkLst>
        </pc:picChg>
        <pc:picChg chg="mod">
          <ac:chgData name="이용인" userId="f23b8f65-dda2-4781-a16d-16fe7c5f2390" providerId="ADAL" clId="{27F8B1FC-0175-4D23-9474-169828BE1CFF}" dt="2024-11-27T01:01:14.302" v="35" actId="1035"/>
          <ac:picMkLst>
            <pc:docMk/>
            <pc:sldMk cId="2372757794" sldId="259"/>
            <ac:picMk id="24" creationId="{7DC948A3-6D04-AC57-99E7-D07EF9A4A783}"/>
          </ac:picMkLst>
        </pc:picChg>
        <pc:picChg chg="mod">
          <ac:chgData name="이용인" userId="f23b8f65-dda2-4781-a16d-16fe7c5f2390" providerId="ADAL" clId="{27F8B1FC-0175-4D23-9474-169828BE1CFF}" dt="2024-11-27T01:01:14.302" v="35" actId="1035"/>
          <ac:picMkLst>
            <pc:docMk/>
            <pc:sldMk cId="2372757794" sldId="259"/>
            <ac:picMk id="26" creationId="{94F01685-6FA9-7AA6-5EA7-4DF3D1BEE4BF}"/>
          </ac:picMkLst>
        </pc:picChg>
        <pc:picChg chg="mod">
          <ac:chgData name="이용인" userId="f23b8f65-dda2-4781-a16d-16fe7c5f2390" providerId="ADAL" clId="{27F8B1FC-0175-4D23-9474-169828BE1CFF}" dt="2024-11-27T01:01:14.302" v="35" actId="1035"/>
          <ac:picMkLst>
            <pc:docMk/>
            <pc:sldMk cId="2372757794" sldId="259"/>
            <ac:picMk id="29" creationId="{B421A1C8-63C9-5D1A-2816-AA7E60782515}"/>
          </ac:picMkLst>
        </pc:picChg>
      </pc:sldChg>
      <pc:sldMasterChg chg="modSp modSldLayout">
        <pc:chgData name="이용인" userId="f23b8f65-dda2-4781-a16d-16fe7c5f2390" providerId="ADAL" clId="{27F8B1FC-0175-4D23-9474-169828BE1CFF}" dt="2024-11-27T01:01:02.004" v="22"/>
        <pc:sldMasterMkLst>
          <pc:docMk/>
          <pc:sldMasterMk cId="3554127385" sldId="2147483660"/>
        </pc:sldMasterMkLst>
        <pc:spChg chg="mod">
          <ac:chgData name="이용인" userId="f23b8f65-dda2-4781-a16d-16fe7c5f2390" providerId="ADAL" clId="{27F8B1FC-0175-4D23-9474-169828BE1CFF}" dt="2024-11-27T01:01:02.004" v="22"/>
          <ac:spMkLst>
            <pc:docMk/>
            <pc:sldMasterMk cId="3554127385" sldId="2147483660"/>
            <ac:spMk id="2" creationId="{00000000-0000-0000-0000-000000000000}"/>
          </ac:spMkLst>
        </pc:spChg>
        <pc:spChg chg="mod">
          <ac:chgData name="이용인" userId="f23b8f65-dda2-4781-a16d-16fe7c5f2390" providerId="ADAL" clId="{27F8B1FC-0175-4D23-9474-169828BE1CFF}" dt="2024-11-27T01:01:02.004" v="22"/>
          <ac:spMkLst>
            <pc:docMk/>
            <pc:sldMasterMk cId="3554127385" sldId="2147483660"/>
            <ac:spMk id="3" creationId="{00000000-0000-0000-0000-000000000000}"/>
          </ac:spMkLst>
        </pc:spChg>
        <pc:spChg chg="mod">
          <ac:chgData name="이용인" userId="f23b8f65-dda2-4781-a16d-16fe7c5f2390" providerId="ADAL" clId="{27F8B1FC-0175-4D23-9474-169828BE1CFF}" dt="2024-11-27T01:01:02.004" v="22"/>
          <ac:spMkLst>
            <pc:docMk/>
            <pc:sldMasterMk cId="3554127385" sldId="2147483660"/>
            <ac:spMk id="4" creationId="{00000000-0000-0000-0000-000000000000}"/>
          </ac:spMkLst>
        </pc:spChg>
        <pc:spChg chg="mod">
          <ac:chgData name="이용인" userId="f23b8f65-dda2-4781-a16d-16fe7c5f2390" providerId="ADAL" clId="{27F8B1FC-0175-4D23-9474-169828BE1CFF}" dt="2024-11-27T01:01:02.004" v="22"/>
          <ac:spMkLst>
            <pc:docMk/>
            <pc:sldMasterMk cId="3554127385" sldId="2147483660"/>
            <ac:spMk id="5" creationId="{00000000-0000-0000-0000-000000000000}"/>
          </ac:spMkLst>
        </pc:spChg>
        <pc:spChg chg="mod">
          <ac:chgData name="이용인" userId="f23b8f65-dda2-4781-a16d-16fe7c5f2390" providerId="ADAL" clId="{27F8B1FC-0175-4D23-9474-169828BE1CFF}" dt="2024-11-27T01:01:02.004" v="22"/>
          <ac:spMkLst>
            <pc:docMk/>
            <pc:sldMasterMk cId="3554127385" sldId="2147483660"/>
            <ac:spMk id="6" creationId="{00000000-0000-0000-0000-000000000000}"/>
          </ac:spMkLst>
        </pc:spChg>
        <pc:sldLayoutChg chg="modSp">
          <pc:chgData name="이용인" userId="f23b8f65-dda2-4781-a16d-16fe7c5f2390" providerId="ADAL" clId="{27F8B1FC-0175-4D23-9474-169828BE1CFF}" dt="2024-11-27T01:01:02.004" v="22"/>
          <pc:sldLayoutMkLst>
            <pc:docMk/>
            <pc:sldMasterMk cId="3554127385" sldId="2147483660"/>
            <pc:sldLayoutMk cId="43787696" sldId="2147483661"/>
          </pc:sldLayoutMkLst>
          <pc:spChg chg="mod">
            <ac:chgData name="이용인" userId="f23b8f65-dda2-4781-a16d-16fe7c5f2390" providerId="ADAL" clId="{27F8B1FC-0175-4D23-9474-169828BE1CFF}" dt="2024-11-27T01:01:02.004" v="22"/>
            <ac:spMkLst>
              <pc:docMk/>
              <pc:sldMasterMk cId="3554127385" sldId="2147483660"/>
              <pc:sldLayoutMk cId="43787696" sldId="2147483661"/>
              <ac:spMk id="2" creationId="{00000000-0000-0000-0000-000000000000}"/>
            </ac:spMkLst>
          </pc:spChg>
          <pc:spChg chg="mod">
            <ac:chgData name="이용인" userId="f23b8f65-dda2-4781-a16d-16fe7c5f2390" providerId="ADAL" clId="{27F8B1FC-0175-4D23-9474-169828BE1CFF}" dt="2024-11-27T01:01:02.004" v="22"/>
            <ac:spMkLst>
              <pc:docMk/>
              <pc:sldMasterMk cId="3554127385" sldId="2147483660"/>
              <pc:sldLayoutMk cId="43787696" sldId="2147483661"/>
              <ac:spMk id="3" creationId="{00000000-0000-0000-0000-000000000000}"/>
            </ac:spMkLst>
          </pc:spChg>
        </pc:sldLayoutChg>
        <pc:sldLayoutChg chg="modSp">
          <pc:chgData name="이용인" userId="f23b8f65-dda2-4781-a16d-16fe7c5f2390" providerId="ADAL" clId="{27F8B1FC-0175-4D23-9474-169828BE1CFF}" dt="2024-11-27T01:01:02.004" v="22"/>
          <pc:sldLayoutMkLst>
            <pc:docMk/>
            <pc:sldMasterMk cId="3554127385" sldId="2147483660"/>
            <pc:sldLayoutMk cId="731469492" sldId="2147483663"/>
          </pc:sldLayoutMkLst>
          <pc:spChg chg="mod">
            <ac:chgData name="이용인" userId="f23b8f65-dda2-4781-a16d-16fe7c5f2390" providerId="ADAL" clId="{27F8B1FC-0175-4D23-9474-169828BE1CFF}" dt="2024-11-27T01:01:02.004" v="22"/>
            <ac:spMkLst>
              <pc:docMk/>
              <pc:sldMasterMk cId="3554127385" sldId="2147483660"/>
              <pc:sldLayoutMk cId="731469492" sldId="2147483663"/>
              <ac:spMk id="2" creationId="{00000000-0000-0000-0000-000000000000}"/>
            </ac:spMkLst>
          </pc:spChg>
          <pc:spChg chg="mod">
            <ac:chgData name="이용인" userId="f23b8f65-dda2-4781-a16d-16fe7c5f2390" providerId="ADAL" clId="{27F8B1FC-0175-4D23-9474-169828BE1CFF}" dt="2024-11-27T01:01:02.004" v="22"/>
            <ac:spMkLst>
              <pc:docMk/>
              <pc:sldMasterMk cId="3554127385" sldId="2147483660"/>
              <pc:sldLayoutMk cId="731469492" sldId="2147483663"/>
              <ac:spMk id="3" creationId="{00000000-0000-0000-0000-000000000000}"/>
            </ac:spMkLst>
          </pc:spChg>
        </pc:sldLayoutChg>
        <pc:sldLayoutChg chg="modSp">
          <pc:chgData name="이용인" userId="f23b8f65-dda2-4781-a16d-16fe7c5f2390" providerId="ADAL" clId="{27F8B1FC-0175-4D23-9474-169828BE1CFF}" dt="2024-11-27T01:01:02.004" v="22"/>
          <pc:sldLayoutMkLst>
            <pc:docMk/>
            <pc:sldMasterMk cId="3554127385" sldId="2147483660"/>
            <pc:sldLayoutMk cId="887370208" sldId="2147483664"/>
          </pc:sldLayoutMkLst>
          <pc:spChg chg="mod">
            <ac:chgData name="이용인" userId="f23b8f65-dda2-4781-a16d-16fe7c5f2390" providerId="ADAL" clId="{27F8B1FC-0175-4D23-9474-169828BE1CFF}" dt="2024-11-27T01:01:02.004" v="22"/>
            <ac:spMkLst>
              <pc:docMk/>
              <pc:sldMasterMk cId="3554127385" sldId="2147483660"/>
              <pc:sldLayoutMk cId="887370208" sldId="2147483664"/>
              <ac:spMk id="3" creationId="{00000000-0000-0000-0000-000000000000}"/>
            </ac:spMkLst>
          </pc:spChg>
          <pc:spChg chg="mod">
            <ac:chgData name="이용인" userId="f23b8f65-dda2-4781-a16d-16fe7c5f2390" providerId="ADAL" clId="{27F8B1FC-0175-4D23-9474-169828BE1CFF}" dt="2024-11-27T01:01:02.004" v="22"/>
            <ac:spMkLst>
              <pc:docMk/>
              <pc:sldMasterMk cId="3554127385" sldId="2147483660"/>
              <pc:sldLayoutMk cId="887370208" sldId="2147483664"/>
              <ac:spMk id="4" creationId="{00000000-0000-0000-0000-000000000000}"/>
            </ac:spMkLst>
          </pc:spChg>
        </pc:sldLayoutChg>
        <pc:sldLayoutChg chg="modSp">
          <pc:chgData name="이용인" userId="f23b8f65-dda2-4781-a16d-16fe7c5f2390" providerId="ADAL" clId="{27F8B1FC-0175-4D23-9474-169828BE1CFF}" dt="2024-11-27T01:01:02.004" v="22"/>
          <pc:sldLayoutMkLst>
            <pc:docMk/>
            <pc:sldMasterMk cId="3554127385" sldId="2147483660"/>
            <pc:sldLayoutMk cId="3555765213" sldId="2147483665"/>
          </pc:sldLayoutMkLst>
          <pc:spChg chg="mod">
            <ac:chgData name="이용인" userId="f23b8f65-dda2-4781-a16d-16fe7c5f2390" providerId="ADAL" clId="{27F8B1FC-0175-4D23-9474-169828BE1CFF}" dt="2024-11-27T01:01:02.004" v="22"/>
            <ac:spMkLst>
              <pc:docMk/>
              <pc:sldMasterMk cId="3554127385" sldId="2147483660"/>
              <pc:sldLayoutMk cId="3555765213" sldId="2147483665"/>
              <ac:spMk id="2" creationId="{00000000-0000-0000-0000-000000000000}"/>
            </ac:spMkLst>
          </pc:spChg>
          <pc:spChg chg="mod">
            <ac:chgData name="이용인" userId="f23b8f65-dda2-4781-a16d-16fe7c5f2390" providerId="ADAL" clId="{27F8B1FC-0175-4D23-9474-169828BE1CFF}" dt="2024-11-27T01:01:02.004" v="22"/>
            <ac:spMkLst>
              <pc:docMk/>
              <pc:sldMasterMk cId="3554127385" sldId="2147483660"/>
              <pc:sldLayoutMk cId="3555765213" sldId="2147483665"/>
              <ac:spMk id="3" creationId="{00000000-0000-0000-0000-000000000000}"/>
            </ac:spMkLst>
          </pc:spChg>
          <pc:spChg chg="mod">
            <ac:chgData name="이용인" userId="f23b8f65-dda2-4781-a16d-16fe7c5f2390" providerId="ADAL" clId="{27F8B1FC-0175-4D23-9474-169828BE1CFF}" dt="2024-11-27T01:01:02.004" v="22"/>
            <ac:spMkLst>
              <pc:docMk/>
              <pc:sldMasterMk cId="3554127385" sldId="2147483660"/>
              <pc:sldLayoutMk cId="3555765213" sldId="2147483665"/>
              <ac:spMk id="4" creationId="{00000000-0000-0000-0000-000000000000}"/>
            </ac:spMkLst>
          </pc:spChg>
          <pc:spChg chg="mod">
            <ac:chgData name="이용인" userId="f23b8f65-dda2-4781-a16d-16fe7c5f2390" providerId="ADAL" clId="{27F8B1FC-0175-4D23-9474-169828BE1CFF}" dt="2024-11-27T01:01:02.004" v="22"/>
            <ac:spMkLst>
              <pc:docMk/>
              <pc:sldMasterMk cId="3554127385" sldId="2147483660"/>
              <pc:sldLayoutMk cId="3555765213" sldId="2147483665"/>
              <ac:spMk id="5" creationId="{00000000-0000-0000-0000-000000000000}"/>
            </ac:spMkLst>
          </pc:spChg>
          <pc:spChg chg="mod">
            <ac:chgData name="이용인" userId="f23b8f65-dda2-4781-a16d-16fe7c5f2390" providerId="ADAL" clId="{27F8B1FC-0175-4D23-9474-169828BE1CFF}" dt="2024-11-27T01:01:02.004" v="22"/>
            <ac:spMkLst>
              <pc:docMk/>
              <pc:sldMasterMk cId="3554127385" sldId="2147483660"/>
              <pc:sldLayoutMk cId="3555765213" sldId="2147483665"/>
              <ac:spMk id="6" creationId="{00000000-0000-0000-0000-000000000000}"/>
            </ac:spMkLst>
          </pc:spChg>
        </pc:sldLayoutChg>
        <pc:sldLayoutChg chg="modSp">
          <pc:chgData name="이용인" userId="f23b8f65-dda2-4781-a16d-16fe7c5f2390" providerId="ADAL" clId="{27F8B1FC-0175-4D23-9474-169828BE1CFF}" dt="2024-11-27T01:01:02.004" v="22"/>
          <pc:sldLayoutMkLst>
            <pc:docMk/>
            <pc:sldMasterMk cId="3554127385" sldId="2147483660"/>
            <pc:sldLayoutMk cId="2616134726" sldId="2147483668"/>
          </pc:sldLayoutMkLst>
          <pc:spChg chg="mod">
            <ac:chgData name="이용인" userId="f23b8f65-dda2-4781-a16d-16fe7c5f2390" providerId="ADAL" clId="{27F8B1FC-0175-4D23-9474-169828BE1CFF}" dt="2024-11-27T01:01:02.004" v="22"/>
            <ac:spMkLst>
              <pc:docMk/>
              <pc:sldMasterMk cId="3554127385" sldId="2147483660"/>
              <pc:sldLayoutMk cId="2616134726" sldId="2147483668"/>
              <ac:spMk id="2" creationId="{00000000-0000-0000-0000-000000000000}"/>
            </ac:spMkLst>
          </pc:spChg>
          <pc:spChg chg="mod">
            <ac:chgData name="이용인" userId="f23b8f65-dda2-4781-a16d-16fe7c5f2390" providerId="ADAL" clId="{27F8B1FC-0175-4D23-9474-169828BE1CFF}" dt="2024-11-27T01:01:02.004" v="22"/>
            <ac:spMkLst>
              <pc:docMk/>
              <pc:sldMasterMk cId="3554127385" sldId="2147483660"/>
              <pc:sldLayoutMk cId="2616134726" sldId="2147483668"/>
              <ac:spMk id="3" creationId="{00000000-0000-0000-0000-000000000000}"/>
            </ac:spMkLst>
          </pc:spChg>
          <pc:spChg chg="mod">
            <ac:chgData name="이용인" userId="f23b8f65-dda2-4781-a16d-16fe7c5f2390" providerId="ADAL" clId="{27F8B1FC-0175-4D23-9474-169828BE1CFF}" dt="2024-11-27T01:01:02.004" v="22"/>
            <ac:spMkLst>
              <pc:docMk/>
              <pc:sldMasterMk cId="3554127385" sldId="2147483660"/>
              <pc:sldLayoutMk cId="2616134726" sldId="2147483668"/>
              <ac:spMk id="4" creationId="{00000000-0000-0000-0000-000000000000}"/>
            </ac:spMkLst>
          </pc:spChg>
        </pc:sldLayoutChg>
        <pc:sldLayoutChg chg="modSp">
          <pc:chgData name="이용인" userId="f23b8f65-dda2-4781-a16d-16fe7c5f2390" providerId="ADAL" clId="{27F8B1FC-0175-4D23-9474-169828BE1CFF}" dt="2024-11-27T01:01:02.004" v="22"/>
          <pc:sldLayoutMkLst>
            <pc:docMk/>
            <pc:sldMasterMk cId="3554127385" sldId="2147483660"/>
            <pc:sldLayoutMk cId="3177690706" sldId="2147483669"/>
          </pc:sldLayoutMkLst>
          <pc:spChg chg="mod">
            <ac:chgData name="이용인" userId="f23b8f65-dda2-4781-a16d-16fe7c5f2390" providerId="ADAL" clId="{27F8B1FC-0175-4D23-9474-169828BE1CFF}" dt="2024-11-27T01:01:02.004" v="22"/>
            <ac:spMkLst>
              <pc:docMk/>
              <pc:sldMasterMk cId="3554127385" sldId="2147483660"/>
              <pc:sldLayoutMk cId="3177690706" sldId="2147483669"/>
              <ac:spMk id="2" creationId="{00000000-0000-0000-0000-000000000000}"/>
            </ac:spMkLst>
          </pc:spChg>
          <pc:spChg chg="mod">
            <ac:chgData name="이용인" userId="f23b8f65-dda2-4781-a16d-16fe7c5f2390" providerId="ADAL" clId="{27F8B1FC-0175-4D23-9474-169828BE1CFF}" dt="2024-11-27T01:01:02.004" v="22"/>
            <ac:spMkLst>
              <pc:docMk/>
              <pc:sldMasterMk cId="3554127385" sldId="2147483660"/>
              <pc:sldLayoutMk cId="3177690706" sldId="2147483669"/>
              <ac:spMk id="3" creationId="{00000000-0000-0000-0000-000000000000}"/>
            </ac:spMkLst>
          </pc:spChg>
          <pc:spChg chg="mod">
            <ac:chgData name="이용인" userId="f23b8f65-dda2-4781-a16d-16fe7c5f2390" providerId="ADAL" clId="{27F8B1FC-0175-4D23-9474-169828BE1CFF}" dt="2024-11-27T01:01:02.004" v="22"/>
            <ac:spMkLst>
              <pc:docMk/>
              <pc:sldMasterMk cId="3554127385" sldId="2147483660"/>
              <pc:sldLayoutMk cId="3177690706" sldId="2147483669"/>
              <ac:spMk id="4" creationId="{00000000-0000-0000-0000-000000000000}"/>
            </ac:spMkLst>
          </pc:spChg>
        </pc:sldLayoutChg>
        <pc:sldLayoutChg chg="modSp">
          <pc:chgData name="이용인" userId="f23b8f65-dda2-4781-a16d-16fe7c5f2390" providerId="ADAL" clId="{27F8B1FC-0175-4D23-9474-169828BE1CFF}" dt="2024-11-27T01:01:02.004" v="22"/>
          <pc:sldLayoutMkLst>
            <pc:docMk/>
            <pc:sldMasterMk cId="3554127385" sldId="2147483660"/>
            <pc:sldLayoutMk cId="639987104" sldId="2147483671"/>
          </pc:sldLayoutMkLst>
          <pc:spChg chg="mod">
            <ac:chgData name="이용인" userId="f23b8f65-dda2-4781-a16d-16fe7c5f2390" providerId="ADAL" clId="{27F8B1FC-0175-4D23-9474-169828BE1CFF}" dt="2024-11-27T01:01:02.004" v="22"/>
            <ac:spMkLst>
              <pc:docMk/>
              <pc:sldMasterMk cId="3554127385" sldId="2147483660"/>
              <pc:sldLayoutMk cId="639987104" sldId="2147483671"/>
              <ac:spMk id="2" creationId="{00000000-0000-0000-0000-000000000000}"/>
            </ac:spMkLst>
          </pc:spChg>
          <pc:spChg chg="mod">
            <ac:chgData name="이용인" userId="f23b8f65-dda2-4781-a16d-16fe7c5f2390" providerId="ADAL" clId="{27F8B1FC-0175-4D23-9474-169828BE1CFF}" dt="2024-11-27T01:01:02.004" v="22"/>
            <ac:spMkLst>
              <pc:docMk/>
              <pc:sldMasterMk cId="3554127385" sldId="2147483660"/>
              <pc:sldLayoutMk cId="639987104" sldId="2147483671"/>
              <ac:spMk id="3" creationId="{00000000-0000-0000-0000-000000000000}"/>
            </ac:spMkLst>
          </pc:spChg>
        </pc:sldLayoutChg>
      </pc:sldMaster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EA9FE0-44A3-468C-A68D-AA727F193DD4}" type="datetimeFigureOut">
              <a:rPr lang="ko-KR" altLang="en-US" smtClean="0"/>
              <a:t>2024-11-2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93688" y="1241425"/>
            <a:ext cx="621030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356472E-FC37-4C62-8B15-15E4AED66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08913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6F9FA28-C866-F01E-7ABB-BEC547C4AA1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>
            <a:extLst>
              <a:ext uri="{FF2B5EF4-FFF2-40B4-BE49-F238E27FC236}">
                <a16:creationId xmlns:a16="http://schemas.microsoft.com/office/drawing/2014/main" id="{0687166E-7386-0576-744A-901391605B48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293688" y="1241425"/>
            <a:ext cx="6210300" cy="3349625"/>
          </a:xfrm>
        </p:spPr>
      </p:sp>
      <p:sp>
        <p:nvSpPr>
          <p:cNvPr id="3" name="슬라이드 노트 개체 틀 2">
            <a:extLst>
              <a:ext uri="{FF2B5EF4-FFF2-40B4-BE49-F238E27FC236}">
                <a16:creationId xmlns:a16="http://schemas.microsoft.com/office/drawing/2014/main" id="{D3E07395-690A-EB98-780A-9028850EC3CE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altLang="ko-KR" dirty="0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37765A96-B65D-90DF-BE0A-6394CFEB641F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356472E-FC37-4C62-8B15-15E4AED66FD3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742584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71277" y="262145"/>
            <a:ext cx="2227660" cy="557660"/>
          </a:xfrm>
        </p:spPr>
        <p:txBody>
          <a:bodyPr anchor="b"/>
          <a:lstStyle>
            <a:lvl1pPr algn="ctr">
              <a:defRPr sz="140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71277" y="841311"/>
            <a:ext cx="2227660" cy="386728"/>
          </a:xfrm>
        </p:spPr>
        <p:txBody>
          <a:bodyPr/>
          <a:lstStyle>
            <a:lvl1pPr marL="0" indent="0" algn="ctr">
              <a:buNone/>
              <a:defRPr sz="561"/>
            </a:lvl1pPr>
            <a:lvl2pPr marL="106802" indent="0" algn="ctr">
              <a:buNone/>
              <a:defRPr sz="467"/>
            </a:lvl2pPr>
            <a:lvl3pPr marL="213604" indent="0" algn="ctr">
              <a:buNone/>
              <a:defRPr sz="420"/>
            </a:lvl3pPr>
            <a:lvl4pPr marL="320406" indent="0" algn="ctr">
              <a:buNone/>
              <a:defRPr sz="374"/>
            </a:lvl4pPr>
            <a:lvl5pPr marL="427208" indent="0" algn="ctr">
              <a:buNone/>
              <a:defRPr sz="374"/>
            </a:lvl5pPr>
            <a:lvl6pPr marL="534010" indent="0" algn="ctr">
              <a:buNone/>
              <a:defRPr sz="374"/>
            </a:lvl6pPr>
            <a:lvl7pPr marL="640812" indent="0" algn="ctr">
              <a:buNone/>
              <a:defRPr sz="374"/>
            </a:lvl7pPr>
            <a:lvl8pPr marL="747613" indent="0" algn="ctr">
              <a:buNone/>
              <a:defRPr sz="374"/>
            </a:lvl8pPr>
            <a:lvl9pPr marL="854415" indent="0" algn="ctr">
              <a:buNone/>
              <a:defRPr sz="374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5C3C53-923C-4B97-B152-1A429E71658D}" type="datetimeFigureOut">
              <a:rPr lang="ko-KR" altLang="en-US" smtClean="0"/>
              <a:t>2024-11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A3042-DFD9-4DE3-83D4-50CA1D5A853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37876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5C3C53-923C-4B97-B152-1A429E71658D}" type="datetimeFigureOut">
              <a:rPr lang="ko-KR" altLang="en-US" smtClean="0"/>
              <a:t>2024-11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A3042-DFD9-4DE3-83D4-50CA1D5A853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813848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125559" y="85281"/>
            <a:ext cx="640452" cy="1357441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04204" y="85281"/>
            <a:ext cx="1884229" cy="1357441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5C3C53-923C-4B97-B152-1A429E71658D}" type="datetimeFigureOut">
              <a:rPr lang="ko-KR" altLang="en-US" smtClean="0"/>
              <a:t>2024-11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A3042-DFD9-4DE3-83D4-50CA1D5A853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399871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5C3C53-923C-4B97-B152-1A429E71658D}" type="datetimeFigureOut">
              <a:rPr lang="ko-KR" altLang="en-US" smtClean="0"/>
              <a:t>2024-11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A3042-DFD9-4DE3-83D4-50CA1D5A853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629949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2657" y="399336"/>
            <a:ext cx="2561809" cy="666299"/>
          </a:xfrm>
        </p:spPr>
        <p:txBody>
          <a:bodyPr anchor="b"/>
          <a:lstStyle>
            <a:lvl1pPr>
              <a:defRPr sz="140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2657" y="1071938"/>
            <a:ext cx="2561809" cy="350391"/>
          </a:xfrm>
        </p:spPr>
        <p:txBody>
          <a:bodyPr/>
          <a:lstStyle>
            <a:lvl1pPr marL="0" indent="0">
              <a:buNone/>
              <a:defRPr sz="561">
                <a:solidFill>
                  <a:schemeClr val="tx1">
                    <a:tint val="82000"/>
                  </a:schemeClr>
                </a:solidFill>
              </a:defRPr>
            </a:lvl1pPr>
            <a:lvl2pPr marL="106802" indent="0">
              <a:buNone/>
              <a:defRPr sz="467">
                <a:solidFill>
                  <a:schemeClr val="tx1">
                    <a:tint val="82000"/>
                  </a:schemeClr>
                </a:solidFill>
              </a:defRPr>
            </a:lvl2pPr>
            <a:lvl3pPr marL="213604" indent="0">
              <a:buNone/>
              <a:defRPr sz="420">
                <a:solidFill>
                  <a:schemeClr val="tx1">
                    <a:tint val="82000"/>
                  </a:schemeClr>
                </a:solidFill>
              </a:defRPr>
            </a:lvl3pPr>
            <a:lvl4pPr marL="320406" indent="0">
              <a:buNone/>
              <a:defRPr sz="374">
                <a:solidFill>
                  <a:schemeClr val="tx1">
                    <a:tint val="82000"/>
                  </a:schemeClr>
                </a:solidFill>
              </a:defRPr>
            </a:lvl4pPr>
            <a:lvl5pPr marL="427208" indent="0">
              <a:buNone/>
              <a:defRPr sz="374">
                <a:solidFill>
                  <a:schemeClr val="tx1">
                    <a:tint val="82000"/>
                  </a:schemeClr>
                </a:solidFill>
              </a:defRPr>
            </a:lvl5pPr>
            <a:lvl6pPr marL="534010" indent="0">
              <a:buNone/>
              <a:defRPr sz="374">
                <a:solidFill>
                  <a:schemeClr val="tx1">
                    <a:tint val="82000"/>
                  </a:schemeClr>
                </a:solidFill>
              </a:defRPr>
            </a:lvl6pPr>
            <a:lvl7pPr marL="640812" indent="0">
              <a:buNone/>
              <a:defRPr sz="374">
                <a:solidFill>
                  <a:schemeClr val="tx1">
                    <a:tint val="82000"/>
                  </a:schemeClr>
                </a:solidFill>
              </a:defRPr>
            </a:lvl7pPr>
            <a:lvl8pPr marL="747613" indent="0">
              <a:buNone/>
              <a:defRPr sz="374">
                <a:solidFill>
                  <a:schemeClr val="tx1">
                    <a:tint val="82000"/>
                  </a:schemeClr>
                </a:solidFill>
              </a:defRPr>
            </a:lvl8pPr>
            <a:lvl9pPr marL="854415" indent="0">
              <a:buNone/>
              <a:defRPr sz="374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5C3C53-923C-4B97-B152-1A429E71658D}" type="datetimeFigureOut">
              <a:rPr lang="ko-KR" altLang="en-US" smtClean="0"/>
              <a:t>2024-11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A3042-DFD9-4DE3-83D4-50CA1D5A853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314694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04204" y="426402"/>
            <a:ext cx="1262341" cy="1016320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03672" y="426402"/>
            <a:ext cx="1262341" cy="1016320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5C3C53-923C-4B97-B152-1A429E71658D}" type="datetimeFigureOut">
              <a:rPr lang="ko-KR" altLang="en-US" smtClean="0"/>
              <a:t>2024-11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A3042-DFD9-4DE3-83D4-50CA1D5A853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873702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4591" y="85280"/>
            <a:ext cx="2561809" cy="30960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4591" y="392662"/>
            <a:ext cx="1256539" cy="192437"/>
          </a:xfrm>
        </p:spPr>
        <p:txBody>
          <a:bodyPr anchor="b"/>
          <a:lstStyle>
            <a:lvl1pPr marL="0" indent="0">
              <a:buNone/>
              <a:defRPr sz="561" b="1"/>
            </a:lvl1pPr>
            <a:lvl2pPr marL="106802" indent="0">
              <a:buNone/>
              <a:defRPr sz="467" b="1"/>
            </a:lvl2pPr>
            <a:lvl3pPr marL="213604" indent="0">
              <a:buNone/>
              <a:defRPr sz="420" b="1"/>
            </a:lvl3pPr>
            <a:lvl4pPr marL="320406" indent="0">
              <a:buNone/>
              <a:defRPr sz="374" b="1"/>
            </a:lvl4pPr>
            <a:lvl5pPr marL="427208" indent="0">
              <a:buNone/>
              <a:defRPr sz="374" b="1"/>
            </a:lvl5pPr>
            <a:lvl6pPr marL="534010" indent="0">
              <a:buNone/>
              <a:defRPr sz="374" b="1"/>
            </a:lvl6pPr>
            <a:lvl7pPr marL="640812" indent="0">
              <a:buNone/>
              <a:defRPr sz="374" b="1"/>
            </a:lvl7pPr>
            <a:lvl8pPr marL="747613" indent="0">
              <a:buNone/>
              <a:defRPr sz="374" b="1"/>
            </a:lvl8pPr>
            <a:lvl9pPr marL="854415" indent="0">
              <a:buNone/>
              <a:defRPr sz="374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04591" y="585099"/>
            <a:ext cx="1256539" cy="860590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503673" y="392662"/>
            <a:ext cx="1262727" cy="192437"/>
          </a:xfrm>
        </p:spPr>
        <p:txBody>
          <a:bodyPr anchor="b"/>
          <a:lstStyle>
            <a:lvl1pPr marL="0" indent="0">
              <a:buNone/>
              <a:defRPr sz="561" b="1"/>
            </a:lvl1pPr>
            <a:lvl2pPr marL="106802" indent="0">
              <a:buNone/>
              <a:defRPr sz="467" b="1"/>
            </a:lvl2pPr>
            <a:lvl3pPr marL="213604" indent="0">
              <a:buNone/>
              <a:defRPr sz="420" b="1"/>
            </a:lvl3pPr>
            <a:lvl4pPr marL="320406" indent="0">
              <a:buNone/>
              <a:defRPr sz="374" b="1"/>
            </a:lvl4pPr>
            <a:lvl5pPr marL="427208" indent="0">
              <a:buNone/>
              <a:defRPr sz="374" b="1"/>
            </a:lvl5pPr>
            <a:lvl6pPr marL="534010" indent="0">
              <a:buNone/>
              <a:defRPr sz="374" b="1"/>
            </a:lvl6pPr>
            <a:lvl7pPr marL="640812" indent="0">
              <a:buNone/>
              <a:defRPr sz="374" b="1"/>
            </a:lvl7pPr>
            <a:lvl8pPr marL="747613" indent="0">
              <a:buNone/>
              <a:defRPr sz="374" b="1"/>
            </a:lvl8pPr>
            <a:lvl9pPr marL="854415" indent="0">
              <a:buNone/>
              <a:defRPr sz="374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503673" y="585099"/>
            <a:ext cx="1262727" cy="860590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5C3C53-923C-4B97-B152-1A429E71658D}" type="datetimeFigureOut">
              <a:rPr lang="ko-KR" altLang="en-US" smtClean="0"/>
              <a:t>2024-11-27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A3042-DFD9-4DE3-83D4-50CA1D5A853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55765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5C3C53-923C-4B97-B152-1A429E71658D}" type="datetimeFigureOut">
              <a:rPr lang="ko-KR" altLang="en-US" smtClean="0"/>
              <a:t>2024-11-27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A3042-DFD9-4DE3-83D4-50CA1D5A853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46949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5C3C53-923C-4B97-B152-1A429E71658D}" type="datetimeFigureOut">
              <a:rPr lang="ko-KR" altLang="en-US" smtClean="0"/>
              <a:t>2024-11-27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A3042-DFD9-4DE3-83D4-50CA1D5A853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173390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4591" y="106787"/>
            <a:ext cx="957971" cy="373751"/>
          </a:xfrm>
        </p:spPr>
        <p:txBody>
          <a:bodyPr anchor="b"/>
          <a:lstStyle>
            <a:lvl1pPr>
              <a:defRPr sz="748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262728" y="230629"/>
            <a:ext cx="1503670" cy="1138308"/>
          </a:xfrm>
        </p:spPr>
        <p:txBody>
          <a:bodyPr/>
          <a:lstStyle>
            <a:lvl1pPr>
              <a:defRPr sz="748"/>
            </a:lvl1pPr>
            <a:lvl2pPr>
              <a:defRPr sz="654"/>
            </a:lvl2pPr>
            <a:lvl3pPr>
              <a:defRPr sz="561"/>
            </a:lvl3pPr>
            <a:lvl4pPr>
              <a:defRPr sz="467"/>
            </a:lvl4pPr>
            <a:lvl5pPr>
              <a:defRPr sz="467"/>
            </a:lvl5pPr>
            <a:lvl6pPr>
              <a:defRPr sz="467"/>
            </a:lvl6pPr>
            <a:lvl7pPr>
              <a:defRPr sz="467"/>
            </a:lvl7pPr>
            <a:lvl8pPr>
              <a:defRPr sz="467"/>
            </a:lvl8pPr>
            <a:lvl9pPr>
              <a:defRPr sz="467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4591" y="480537"/>
            <a:ext cx="957971" cy="890253"/>
          </a:xfrm>
        </p:spPr>
        <p:txBody>
          <a:bodyPr/>
          <a:lstStyle>
            <a:lvl1pPr marL="0" indent="0">
              <a:buNone/>
              <a:defRPr sz="374"/>
            </a:lvl1pPr>
            <a:lvl2pPr marL="106802" indent="0">
              <a:buNone/>
              <a:defRPr sz="327"/>
            </a:lvl2pPr>
            <a:lvl3pPr marL="213604" indent="0">
              <a:buNone/>
              <a:defRPr sz="280"/>
            </a:lvl3pPr>
            <a:lvl4pPr marL="320406" indent="0">
              <a:buNone/>
              <a:defRPr sz="234"/>
            </a:lvl4pPr>
            <a:lvl5pPr marL="427208" indent="0">
              <a:buNone/>
              <a:defRPr sz="234"/>
            </a:lvl5pPr>
            <a:lvl6pPr marL="534010" indent="0">
              <a:buNone/>
              <a:defRPr sz="234"/>
            </a:lvl6pPr>
            <a:lvl7pPr marL="640812" indent="0">
              <a:buNone/>
              <a:defRPr sz="234"/>
            </a:lvl7pPr>
            <a:lvl8pPr marL="747613" indent="0">
              <a:buNone/>
              <a:defRPr sz="234"/>
            </a:lvl8pPr>
            <a:lvl9pPr marL="854415" indent="0">
              <a:buNone/>
              <a:defRPr sz="234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5C3C53-923C-4B97-B152-1A429E71658D}" type="datetimeFigureOut">
              <a:rPr lang="ko-KR" altLang="en-US" smtClean="0"/>
              <a:t>2024-11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A3042-DFD9-4DE3-83D4-50CA1D5A853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61347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4591" y="106787"/>
            <a:ext cx="957971" cy="373751"/>
          </a:xfrm>
        </p:spPr>
        <p:txBody>
          <a:bodyPr anchor="b"/>
          <a:lstStyle>
            <a:lvl1pPr>
              <a:defRPr sz="748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262728" y="230629"/>
            <a:ext cx="1503670" cy="1138308"/>
          </a:xfrm>
        </p:spPr>
        <p:txBody>
          <a:bodyPr anchor="t"/>
          <a:lstStyle>
            <a:lvl1pPr marL="0" indent="0">
              <a:buNone/>
              <a:defRPr sz="748"/>
            </a:lvl1pPr>
            <a:lvl2pPr marL="106802" indent="0">
              <a:buNone/>
              <a:defRPr sz="654"/>
            </a:lvl2pPr>
            <a:lvl3pPr marL="213604" indent="0">
              <a:buNone/>
              <a:defRPr sz="561"/>
            </a:lvl3pPr>
            <a:lvl4pPr marL="320406" indent="0">
              <a:buNone/>
              <a:defRPr sz="467"/>
            </a:lvl4pPr>
            <a:lvl5pPr marL="427208" indent="0">
              <a:buNone/>
              <a:defRPr sz="467"/>
            </a:lvl5pPr>
            <a:lvl6pPr marL="534010" indent="0">
              <a:buNone/>
              <a:defRPr sz="467"/>
            </a:lvl6pPr>
            <a:lvl7pPr marL="640812" indent="0">
              <a:buNone/>
              <a:defRPr sz="467"/>
            </a:lvl7pPr>
            <a:lvl8pPr marL="747613" indent="0">
              <a:buNone/>
              <a:defRPr sz="467"/>
            </a:lvl8pPr>
            <a:lvl9pPr marL="854415" indent="0">
              <a:buNone/>
              <a:defRPr sz="467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4591" y="480537"/>
            <a:ext cx="957971" cy="890253"/>
          </a:xfrm>
        </p:spPr>
        <p:txBody>
          <a:bodyPr/>
          <a:lstStyle>
            <a:lvl1pPr marL="0" indent="0">
              <a:buNone/>
              <a:defRPr sz="374"/>
            </a:lvl1pPr>
            <a:lvl2pPr marL="106802" indent="0">
              <a:buNone/>
              <a:defRPr sz="327"/>
            </a:lvl2pPr>
            <a:lvl3pPr marL="213604" indent="0">
              <a:buNone/>
              <a:defRPr sz="280"/>
            </a:lvl3pPr>
            <a:lvl4pPr marL="320406" indent="0">
              <a:buNone/>
              <a:defRPr sz="234"/>
            </a:lvl4pPr>
            <a:lvl5pPr marL="427208" indent="0">
              <a:buNone/>
              <a:defRPr sz="234"/>
            </a:lvl5pPr>
            <a:lvl6pPr marL="534010" indent="0">
              <a:buNone/>
              <a:defRPr sz="234"/>
            </a:lvl6pPr>
            <a:lvl7pPr marL="640812" indent="0">
              <a:buNone/>
              <a:defRPr sz="234"/>
            </a:lvl7pPr>
            <a:lvl8pPr marL="747613" indent="0">
              <a:buNone/>
              <a:defRPr sz="234"/>
            </a:lvl8pPr>
            <a:lvl9pPr marL="854415" indent="0">
              <a:buNone/>
              <a:defRPr sz="234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5C3C53-923C-4B97-B152-1A429E71658D}" type="datetimeFigureOut">
              <a:rPr lang="ko-KR" altLang="en-US" smtClean="0"/>
              <a:t>2024-11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A3042-DFD9-4DE3-83D4-50CA1D5A853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776907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04202" y="85280"/>
            <a:ext cx="2561809" cy="3096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4202" y="426402"/>
            <a:ext cx="2561809" cy="101632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04202" y="1484620"/>
            <a:ext cx="668298" cy="852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8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45C3C53-923C-4B97-B152-1A429E71658D}" type="datetimeFigureOut">
              <a:rPr lang="ko-KR" altLang="en-US" smtClean="0"/>
              <a:t>2024-11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83883" y="1484620"/>
            <a:ext cx="1002447" cy="852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8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097713" y="1484620"/>
            <a:ext cx="668298" cy="852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8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2EA3042-DFD9-4DE3-83D4-50CA1D5A853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541273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213604" rtl="0" eaLnBrk="1" latinLnBrk="1" hangingPunct="1">
        <a:lnSpc>
          <a:spcPct val="90000"/>
        </a:lnSpc>
        <a:spcBef>
          <a:spcPct val="0"/>
        </a:spcBef>
        <a:buNone/>
        <a:defRPr sz="102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3401" indent="-53401" algn="l" defTabSz="213604" rtl="0" eaLnBrk="1" latinLnBrk="1" hangingPunct="1">
        <a:lnSpc>
          <a:spcPct val="90000"/>
        </a:lnSpc>
        <a:spcBef>
          <a:spcPts val="234"/>
        </a:spcBef>
        <a:buFont typeface="Arial" panose="020B0604020202020204" pitchFamily="34" charset="0"/>
        <a:buChar char="•"/>
        <a:defRPr sz="654" kern="1200">
          <a:solidFill>
            <a:schemeClr val="tx1"/>
          </a:solidFill>
          <a:latin typeface="+mn-lt"/>
          <a:ea typeface="+mn-ea"/>
          <a:cs typeface="+mn-cs"/>
        </a:defRPr>
      </a:lvl1pPr>
      <a:lvl2pPr marL="160203" indent="-53401" algn="l" defTabSz="213604" rtl="0" eaLnBrk="1" latinLnBrk="1" hangingPunct="1">
        <a:lnSpc>
          <a:spcPct val="90000"/>
        </a:lnSpc>
        <a:spcBef>
          <a:spcPts val="117"/>
        </a:spcBef>
        <a:buFont typeface="Arial" panose="020B0604020202020204" pitchFamily="34" charset="0"/>
        <a:buChar char="•"/>
        <a:defRPr sz="561" kern="1200">
          <a:solidFill>
            <a:schemeClr val="tx1"/>
          </a:solidFill>
          <a:latin typeface="+mn-lt"/>
          <a:ea typeface="+mn-ea"/>
          <a:cs typeface="+mn-cs"/>
        </a:defRPr>
      </a:lvl2pPr>
      <a:lvl3pPr marL="267005" indent="-53401" algn="l" defTabSz="213604" rtl="0" eaLnBrk="1" latinLnBrk="1" hangingPunct="1">
        <a:lnSpc>
          <a:spcPct val="90000"/>
        </a:lnSpc>
        <a:spcBef>
          <a:spcPts val="117"/>
        </a:spcBef>
        <a:buFont typeface="Arial" panose="020B0604020202020204" pitchFamily="34" charset="0"/>
        <a:buChar char="•"/>
        <a:defRPr sz="467" kern="1200">
          <a:solidFill>
            <a:schemeClr val="tx1"/>
          </a:solidFill>
          <a:latin typeface="+mn-lt"/>
          <a:ea typeface="+mn-ea"/>
          <a:cs typeface="+mn-cs"/>
        </a:defRPr>
      </a:lvl3pPr>
      <a:lvl4pPr marL="373807" indent="-53401" algn="l" defTabSz="213604" rtl="0" eaLnBrk="1" latinLnBrk="1" hangingPunct="1">
        <a:lnSpc>
          <a:spcPct val="90000"/>
        </a:lnSpc>
        <a:spcBef>
          <a:spcPts val="117"/>
        </a:spcBef>
        <a:buFont typeface="Arial" panose="020B0604020202020204" pitchFamily="34" charset="0"/>
        <a:buChar char="•"/>
        <a:defRPr sz="420" kern="1200">
          <a:solidFill>
            <a:schemeClr val="tx1"/>
          </a:solidFill>
          <a:latin typeface="+mn-lt"/>
          <a:ea typeface="+mn-ea"/>
          <a:cs typeface="+mn-cs"/>
        </a:defRPr>
      </a:lvl4pPr>
      <a:lvl5pPr marL="480609" indent="-53401" algn="l" defTabSz="213604" rtl="0" eaLnBrk="1" latinLnBrk="1" hangingPunct="1">
        <a:lnSpc>
          <a:spcPct val="90000"/>
        </a:lnSpc>
        <a:spcBef>
          <a:spcPts val="117"/>
        </a:spcBef>
        <a:buFont typeface="Arial" panose="020B0604020202020204" pitchFamily="34" charset="0"/>
        <a:buChar char="•"/>
        <a:defRPr sz="420" kern="1200">
          <a:solidFill>
            <a:schemeClr val="tx1"/>
          </a:solidFill>
          <a:latin typeface="+mn-lt"/>
          <a:ea typeface="+mn-ea"/>
          <a:cs typeface="+mn-cs"/>
        </a:defRPr>
      </a:lvl5pPr>
      <a:lvl6pPr marL="587411" indent="-53401" algn="l" defTabSz="213604" rtl="0" eaLnBrk="1" latinLnBrk="1" hangingPunct="1">
        <a:lnSpc>
          <a:spcPct val="90000"/>
        </a:lnSpc>
        <a:spcBef>
          <a:spcPts val="117"/>
        </a:spcBef>
        <a:buFont typeface="Arial" panose="020B0604020202020204" pitchFamily="34" charset="0"/>
        <a:buChar char="•"/>
        <a:defRPr sz="420" kern="1200">
          <a:solidFill>
            <a:schemeClr val="tx1"/>
          </a:solidFill>
          <a:latin typeface="+mn-lt"/>
          <a:ea typeface="+mn-ea"/>
          <a:cs typeface="+mn-cs"/>
        </a:defRPr>
      </a:lvl6pPr>
      <a:lvl7pPr marL="694212" indent="-53401" algn="l" defTabSz="213604" rtl="0" eaLnBrk="1" latinLnBrk="1" hangingPunct="1">
        <a:lnSpc>
          <a:spcPct val="90000"/>
        </a:lnSpc>
        <a:spcBef>
          <a:spcPts val="117"/>
        </a:spcBef>
        <a:buFont typeface="Arial" panose="020B0604020202020204" pitchFamily="34" charset="0"/>
        <a:buChar char="•"/>
        <a:defRPr sz="420" kern="1200">
          <a:solidFill>
            <a:schemeClr val="tx1"/>
          </a:solidFill>
          <a:latin typeface="+mn-lt"/>
          <a:ea typeface="+mn-ea"/>
          <a:cs typeface="+mn-cs"/>
        </a:defRPr>
      </a:lvl7pPr>
      <a:lvl8pPr marL="801014" indent="-53401" algn="l" defTabSz="213604" rtl="0" eaLnBrk="1" latinLnBrk="1" hangingPunct="1">
        <a:lnSpc>
          <a:spcPct val="90000"/>
        </a:lnSpc>
        <a:spcBef>
          <a:spcPts val="117"/>
        </a:spcBef>
        <a:buFont typeface="Arial" panose="020B0604020202020204" pitchFamily="34" charset="0"/>
        <a:buChar char="•"/>
        <a:defRPr sz="420" kern="1200">
          <a:solidFill>
            <a:schemeClr val="tx1"/>
          </a:solidFill>
          <a:latin typeface="+mn-lt"/>
          <a:ea typeface="+mn-ea"/>
          <a:cs typeface="+mn-cs"/>
        </a:defRPr>
      </a:lvl8pPr>
      <a:lvl9pPr marL="907816" indent="-53401" algn="l" defTabSz="213604" rtl="0" eaLnBrk="1" latinLnBrk="1" hangingPunct="1">
        <a:lnSpc>
          <a:spcPct val="90000"/>
        </a:lnSpc>
        <a:spcBef>
          <a:spcPts val="117"/>
        </a:spcBef>
        <a:buFont typeface="Arial" panose="020B0604020202020204" pitchFamily="34" charset="0"/>
        <a:buChar char="•"/>
        <a:defRPr sz="4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13604" rtl="0" eaLnBrk="1" latinLnBrk="1" hangingPunct="1">
        <a:defRPr sz="420" kern="1200">
          <a:solidFill>
            <a:schemeClr val="tx1"/>
          </a:solidFill>
          <a:latin typeface="+mn-lt"/>
          <a:ea typeface="+mn-ea"/>
          <a:cs typeface="+mn-cs"/>
        </a:defRPr>
      </a:lvl1pPr>
      <a:lvl2pPr marL="106802" algn="l" defTabSz="213604" rtl="0" eaLnBrk="1" latinLnBrk="1" hangingPunct="1">
        <a:defRPr sz="420" kern="1200">
          <a:solidFill>
            <a:schemeClr val="tx1"/>
          </a:solidFill>
          <a:latin typeface="+mn-lt"/>
          <a:ea typeface="+mn-ea"/>
          <a:cs typeface="+mn-cs"/>
        </a:defRPr>
      </a:lvl2pPr>
      <a:lvl3pPr marL="213604" algn="l" defTabSz="213604" rtl="0" eaLnBrk="1" latinLnBrk="1" hangingPunct="1">
        <a:defRPr sz="420" kern="1200">
          <a:solidFill>
            <a:schemeClr val="tx1"/>
          </a:solidFill>
          <a:latin typeface="+mn-lt"/>
          <a:ea typeface="+mn-ea"/>
          <a:cs typeface="+mn-cs"/>
        </a:defRPr>
      </a:lvl3pPr>
      <a:lvl4pPr marL="320406" algn="l" defTabSz="213604" rtl="0" eaLnBrk="1" latinLnBrk="1" hangingPunct="1">
        <a:defRPr sz="420" kern="1200">
          <a:solidFill>
            <a:schemeClr val="tx1"/>
          </a:solidFill>
          <a:latin typeface="+mn-lt"/>
          <a:ea typeface="+mn-ea"/>
          <a:cs typeface="+mn-cs"/>
        </a:defRPr>
      </a:lvl4pPr>
      <a:lvl5pPr marL="427208" algn="l" defTabSz="213604" rtl="0" eaLnBrk="1" latinLnBrk="1" hangingPunct="1">
        <a:defRPr sz="420" kern="1200">
          <a:solidFill>
            <a:schemeClr val="tx1"/>
          </a:solidFill>
          <a:latin typeface="+mn-lt"/>
          <a:ea typeface="+mn-ea"/>
          <a:cs typeface="+mn-cs"/>
        </a:defRPr>
      </a:lvl5pPr>
      <a:lvl6pPr marL="534010" algn="l" defTabSz="213604" rtl="0" eaLnBrk="1" latinLnBrk="1" hangingPunct="1">
        <a:defRPr sz="420" kern="1200">
          <a:solidFill>
            <a:schemeClr val="tx1"/>
          </a:solidFill>
          <a:latin typeface="+mn-lt"/>
          <a:ea typeface="+mn-ea"/>
          <a:cs typeface="+mn-cs"/>
        </a:defRPr>
      </a:lvl6pPr>
      <a:lvl7pPr marL="640812" algn="l" defTabSz="213604" rtl="0" eaLnBrk="1" latinLnBrk="1" hangingPunct="1">
        <a:defRPr sz="420" kern="1200">
          <a:solidFill>
            <a:schemeClr val="tx1"/>
          </a:solidFill>
          <a:latin typeface="+mn-lt"/>
          <a:ea typeface="+mn-ea"/>
          <a:cs typeface="+mn-cs"/>
        </a:defRPr>
      </a:lvl7pPr>
      <a:lvl8pPr marL="747613" algn="l" defTabSz="213604" rtl="0" eaLnBrk="1" latinLnBrk="1" hangingPunct="1">
        <a:defRPr sz="420" kern="1200">
          <a:solidFill>
            <a:schemeClr val="tx1"/>
          </a:solidFill>
          <a:latin typeface="+mn-lt"/>
          <a:ea typeface="+mn-ea"/>
          <a:cs typeface="+mn-cs"/>
        </a:defRPr>
      </a:lvl8pPr>
      <a:lvl9pPr marL="854415" algn="l" defTabSz="213604" rtl="0" eaLnBrk="1" latinLnBrk="1" hangingPunct="1">
        <a:defRPr sz="4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png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Relationship Id="rId9" Type="http://schemas.openxmlformats.org/officeDocument/2006/relationships/image" Target="../media/image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CB0CE55-DAB9-1425-C58D-99975DD9AF2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그룹 13">
            <a:extLst>
              <a:ext uri="{FF2B5EF4-FFF2-40B4-BE49-F238E27FC236}">
                <a16:creationId xmlns:a16="http://schemas.microsoft.com/office/drawing/2014/main" id="{277B1270-88BE-68E4-3012-A4C9631C0ED2}"/>
              </a:ext>
            </a:extLst>
          </p:cNvPr>
          <p:cNvGrpSpPr/>
          <p:nvPr/>
        </p:nvGrpSpPr>
        <p:grpSpPr>
          <a:xfrm>
            <a:off x="32232" y="348460"/>
            <a:ext cx="843760" cy="686744"/>
            <a:chOff x="103636" y="443669"/>
            <a:chExt cx="742239" cy="604115"/>
          </a:xfrm>
        </p:grpSpPr>
        <p:pic>
          <p:nvPicPr>
            <p:cNvPr id="15" name="Picture 2" descr="Free ginseng wild ginseng nature illustration">
              <a:extLst>
                <a:ext uri="{FF2B5EF4-FFF2-40B4-BE49-F238E27FC236}">
                  <a16:creationId xmlns:a16="http://schemas.microsoft.com/office/drawing/2014/main" id="{4563EE25-B4C6-9242-5F84-DD897614780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alphaModFix amt="7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2698" y="443669"/>
              <a:ext cx="604114" cy="604115"/>
            </a:xfrm>
            <a:prstGeom prst="rect">
              <a:avLst/>
            </a:prstGeom>
            <a:solidFill>
              <a:schemeClr val="bg1"/>
            </a:solidFill>
          </p:spPr>
        </p:pic>
        <p:grpSp>
          <p:nvGrpSpPr>
            <p:cNvPr id="7" name="그룹 6">
              <a:extLst>
                <a:ext uri="{FF2B5EF4-FFF2-40B4-BE49-F238E27FC236}">
                  <a16:creationId xmlns:a16="http://schemas.microsoft.com/office/drawing/2014/main" id="{2C74588A-E64E-D7FE-C673-2DD7D1FDC352}"/>
                </a:ext>
              </a:extLst>
            </p:cNvPr>
            <p:cNvGrpSpPr/>
            <p:nvPr/>
          </p:nvGrpSpPr>
          <p:grpSpPr>
            <a:xfrm>
              <a:off x="103636" y="478237"/>
              <a:ext cx="742239" cy="518315"/>
              <a:chOff x="61384" y="533405"/>
              <a:chExt cx="742239" cy="518315"/>
            </a:xfrm>
          </p:grpSpPr>
          <p:grpSp>
            <p:nvGrpSpPr>
              <p:cNvPr id="34" name="그룹 33">
                <a:extLst>
                  <a:ext uri="{FF2B5EF4-FFF2-40B4-BE49-F238E27FC236}">
                    <a16:creationId xmlns:a16="http://schemas.microsoft.com/office/drawing/2014/main" id="{0B018152-84B6-F24A-4EFD-8074C520F139}"/>
                  </a:ext>
                </a:extLst>
              </p:cNvPr>
              <p:cNvGrpSpPr/>
              <p:nvPr/>
            </p:nvGrpSpPr>
            <p:grpSpPr>
              <a:xfrm>
                <a:off x="69522" y="533405"/>
                <a:ext cx="397500" cy="261702"/>
                <a:chOff x="68130" y="465073"/>
                <a:chExt cx="397500" cy="261702"/>
              </a:xfrm>
            </p:grpSpPr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33C9FB1F-3466-8E2A-3442-2B50B12DC6A4}"/>
                    </a:ext>
                  </a:extLst>
                </p:cNvPr>
                <p:cNvSpPr txBox="1"/>
                <p:nvPr/>
              </p:nvSpPr>
              <p:spPr>
                <a:xfrm>
                  <a:off x="144213" y="604940"/>
                  <a:ext cx="220263" cy="12183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3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Rb</a:t>
                  </a:r>
                  <a:r>
                    <a:rPr lang="en-US" altLang="ko-KR" sz="300" b="1" baseline="-2500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lang="ko-KR" altLang="en-US" sz="3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29" name="Picture 4">
                  <a:extLst>
                    <a:ext uri="{FF2B5EF4-FFF2-40B4-BE49-F238E27FC236}">
                      <a16:creationId xmlns:a16="http://schemas.microsoft.com/office/drawing/2014/main" id="{B421A1C8-63C9-5D1A-2816-AA7E60782515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68130" y="465073"/>
                  <a:ext cx="397500" cy="188847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</p:grpSp>
          <p:grpSp>
            <p:nvGrpSpPr>
              <p:cNvPr id="36" name="그룹 35">
                <a:extLst>
                  <a:ext uri="{FF2B5EF4-FFF2-40B4-BE49-F238E27FC236}">
                    <a16:creationId xmlns:a16="http://schemas.microsoft.com/office/drawing/2014/main" id="{66EA0BDF-30AE-70D4-9B9D-BA2B38531297}"/>
                  </a:ext>
                </a:extLst>
              </p:cNvPr>
              <p:cNvGrpSpPr/>
              <p:nvPr/>
            </p:nvGrpSpPr>
            <p:grpSpPr>
              <a:xfrm>
                <a:off x="406041" y="533405"/>
                <a:ext cx="397582" cy="261702"/>
                <a:chOff x="485616" y="465073"/>
                <a:chExt cx="397582" cy="261702"/>
              </a:xfrm>
            </p:grpSpPr>
            <p:pic>
              <p:nvPicPr>
                <p:cNvPr id="26" name="Picture 6">
                  <a:extLst>
                    <a:ext uri="{FF2B5EF4-FFF2-40B4-BE49-F238E27FC236}">
                      <a16:creationId xmlns:a16="http://schemas.microsoft.com/office/drawing/2014/main" id="{94F01685-6FA9-7AA6-5EA7-4DF3D1BEE4BF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85616" y="465073"/>
                  <a:ext cx="397582" cy="188886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9D764975-30E8-D2E5-AAFE-AC22A7248FD4}"/>
                    </a:ext>
                  </a:extLst>
                </p:cNvPr>
                <p:cNvSpPr txBox="1"/>
                <p:nvPr/>
              </p:nvSpPr>
              <p:spPr>
                <a:xfrm>
                  <a:off x="572628" y="604940"/>
                  <a:ext cx="204751" cy="12183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3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Rc</a:t>
                  </a:r>
                  <a:endParaRPr lang="ko-KR" altLang="en-US" sz="3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5" name="그룹 34">
                <a:extLst>
                  <a:ext uri="{FF2B5EF4-FFF2-40B4-BE49-F238E27FC236}">
                    <a16:creationId xmlns:a16="http://schemas.microsoft.com/office/drawing/2014/main" id="{AAB9B22E-BB66-719D-34D3-384CBF749121}"/>
                  </a:ext>
                </a:extLst>
              </p:cNvPr>
              <p:cNvGrpSpPr/>
              <p:nvPr/>
            </p:nvGrpSpPr>
            <p:grpSpPr>
              <a:xfrm>
                <a:off x="61384" y="778495"/>
                <a:ext cx="405638" cy="273225"/>
                <a:chOff x="59992" y="710163"/>
                <a:chExt cx="405638" cy="273225"/>
              </a:xfrm>
            </p:grpSpPr>
            <p:pic>
              <p:nvPicPr>
                <p:cNvPr id="24" name="Picture 5">
                  <a:extLst>
                    <a:ext uri="{FF2B5EF4-FFF2-40B4-BE49-F238E27FC236}">
                      <a16:creationId xmlns:a16="http://schemas.microsoft.com/office/drawing/2014/main" id="{7DC948A3-6D04-AC57-99E7-D07EF9A4A783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59992" y="710163"/>
                  <a:ext cx="405638" cy="19271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83E833DB-9E6D-9DE0-E2CE-9CFAFC8A1A83}"/>
                    </a:ext>
                  </a:extLst>
                </p:cNvPr>
                <p:cNvSpPr txBox="1"/>
                <p:nvPr/>
              </p:nvSpPr>
              <p:spPr>
                <a:xfrm>
                  <a:off x="140822" y="861553"/>
                  <a:ext cx="220263" cy="12183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3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Rb</a:t>
                  </a:r>
                  <a:r>
                    <a:rPr lang="en-US" altLang="ko-KR" sz="300" b="1" baseline="-2500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lang="ko-KR" altLang="en-US" sz="3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7" name="그룹 36">
                <a:extLst>
                  <a:ext uri="{FF2B5EF4-FFF2-40B4-BE49-F238E27FC236}">
                    <a16:creationId xmlns:a16="http://schemas.microsoft.com/office/drawing/2014/main" id="{E25DD6D0-FE30-9386-56C5-7DBCFFB9FCE0}"/>
                  </a:ext>
                </a:extLst>
              </p:cNvPr>
              <p:cNvGrpSpPr/>
              <p:nvPr/>
            </p:nvGrpSpPr>
            <p:grpSpPr>
              <a:xfrm>
                <a:off x="406041" y="778496"/>
                <a:ext cx="397582" cy="273224"/>
                <a:chOff x="485616" y="710164"/>
                <a:chExt cx="397582" cy="273224"/>
              </a:xfrm>
            </p:grpSpPr>
            <p:pic>
              <p:nvPicPr>
                <p:cNvPr id="22" name="Picture 7">
                  <a:extLst>
                    <a:ext uri="{FF2B5EF4-FFF2-40B4-BE49-F238E27FC236}">
                      <a16:creationId xmlns:a16="http://schemas.microsoft.com/office/drawing/2014/main" id="{0856FE5C-B91E-D45C-A669-5346D794CB45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85616" y="710164"/>
                  <a:ext cx="397582" cy="188886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E355372A-4FC4-1362-7885-C72344ED2097}"/>
                    </a:ext>
                  </a:extLst>
                </p:cNvPr>
                <p:cNvSpPr txBox="1"/>
                <p:nvPr/>
              </p:nvSpPr>
              <p:spPr>
                <a:xfrm>
                  <a:off x="586602" y="861553"/>
                  <a:ext cx="207571" cy="12183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3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Rd</a:t>
                  </a:r>
                  <a:endParaRPr lang="ko-KR" altLang="en-US" sz="3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grpSp>
        <p:nvGrpSpPr>
          <p:cNvPr id="11" name="그룹 10">
            <a:extLst>
              <a:ext uri="{FF2B5EF4-FFF2-40B4-BE49-F238E27FC236}">
                <a16:creationId xmlns:a16="http://schemas.microsoft.com/office/drawing/2014/main" id="{CA6925CA-9FB0-1C43-1539-0055BF9C6B27}"/>
              </a:ext>
            </a:extLst>
          </p:cNvPr>
          <p:cNvGrpSpPr/>
          <p:nvPr/>
        </p:nvGrpSpPr>
        <p:grpSpPr>
          <a:xfrm>
            <a:off x="2257344" y="496153"/>
            <a:ext cx="673468" cy="618803"/>
            <a:chOff x="4758003" y="2400561"/>
            <a:chExt cx="1242744" cy="1141875"/>
          </a:xfrm>
        </p:grpSpPr>
        <p:pic>
          <p:nvPicPr>
            <p:cNvPr id="12" name="Picture 13">
              <a:extLst>
                <a:ext uri="{FF2B5EF4-FFF2-40B4-BE49-F238E27FC236}">
                  <a16:creationId xmlns:a16="http://schemas.microsoft.com/office/drawing/2014/main" id="{920A5376-9D03-44C5-C02B-174BAB711EF7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58003" y="2400561"/>
              <a:ext cx="1242744" cy="7664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2AF0F58C-28F2-6763-9074-D9AF90DFA356}"/>
                </a:ext>
              </a:extLst>
            </p:cNvPr>
            <p:cNvSpPr txBox="1"/>
            <p:nvPr/>
          </p:nvSpPr>
          <p:spPr>
            <a:xfrm>
              <a:off x="5140960" y="3258467"/>
              <a:ext cx="476830" cy="2839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400" b="1">
                  <a:latin typeface="arial" panose="020B0604020202020204" pitchFamily="34" charset="0"/>
                  <a:cs typeface="arial" panose="020B0604020202020204" pitchFamily="34" charset="0"/>
                </a:rPr>
                <a:t>CK</a:t>
              </a:r>
              <a:endParaRPr lang="ko-KR" altLang="en-US" sz="924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1BEDB21A-198D-AB5A-A337-6C2E007E9E21}"/>
              </a:ext>
            </a:extLst>
          </p:cNvPr>
          <p:cNvSpPr txBox="1"/>
          <p:nvPr/>
        </p:nvSpPr>
        <p:spPr>
          <a:xfrm>
            <a:off x="-38250" y="958261"/>
            <a:ext cx="98296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400" b="1">
                <a:latin typeface="arial" panose="020B0604020202020204" pitchFamily="34" charset="0"/>
                <a:cs typeface="arial" panose="020B0604020202020204" pitchFamily="34" charset="0"/>
              </a:rPr>
              <a:t>40 g/L American ginseng extract</a:t>
            </a:r>
            <a:endParaRPr lang="ko-KR" altLang="en-US" sz="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화살표: U자형 29">
            <a:extLst>
              <a:ext uri="{FF2B5EF4-FFF2-40B4-BE49-F238E27FC236}">
                <a16:creationId xmlns:a16="http://schemas.microsoft.com/office/drawing/2014/main" id="{7F8F8532-F2EC-052E-66C2-FBFC42D3C6D0}"/>
              </a:ext>
            </a:extLst>
          </p:cNvPr>
          <p:cNvSpPr/>
          <p:nvPr/>
        </p:nvSpPr>
        <p:spPr>
          <a:xfrm>
            <a:off x="444987" y="234842"/>
            <a:ext cx="2072783" cy="191712"/>
          </a:xfrm>
          <a:prstGeom prst="uturnArrow">
            <a:avLst>
              <a:gd name="adj1" fmla="val 18415"/>
              <a:gd name="adj2" fmla="val 25000"/>
              <a:gd name="adj3" fmla="val 38249"/>
              <a:gd name="adj4" fmla="val 73705"/>
              <a:gd name="adj5" fmla="val 100000"/>
            </a:avLst>
          </a:prstGeom>
          <a:gradFill flip="none" rotWithShape="1">
            <a:gsLst>
              <a:gs pos="50000">
                <a:srgbClr val="B0E5FA"/>
              </a:gs>
              <a:gs pos="100000">
                <a:schemeClr val="bg1"/>
              </a:gs>
              <a:gs pos="0">
                <a:schemeClr val="accent4">
                  <a:lumMod val="60000"/>
                  <a:lumOff val="40000"/>
                </a:schemeClr>
              </a:gs>
            </a:gsLst>
            <a:lin ang="10800000" scaled="1"/>
            <a:tileRect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F9D4236-B68B-CEF0-A221-9235719D0056}"/>
              </a:ext>
            </a:extLst>
          </p:cNvPr>
          <p:cNvSpPr txBox="1"/>
          <p:nvPr/>
        </p:nvSpPr>
        <p:spPr>
          <a:xfrm>
            <a:off x="1215048" y="105070"/>
            <a:ext cx="51328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400" b="1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ermentation</a:t>
            </a:r>
            <a:endParaRPr lang="ko-KR" altLang="en-US" sz="400" b="1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그룹 4">
            <a:extLst>
              <a:ext uri="{FF2B5EF4-FFF2-40B4-BE49-F238E27FC236}">
                <a16:creationId xmlns:a16="http://schemas.microsoft.com/office/drawing/2014/main" id="{17090803-FD37-4778-3166-0061F38D8B84}"/>
              </a:ext>
            </a:extLst>
          </p:cNvPr>
          <p:cNvGrpSpPr/>
          <p:nvPr/>
        </p:nvGrpSpPr>
        <p:grpSpPr>
          <a:xfrm>
            <a:off x="853928" y="359857"/>
            <a:ext cx="1417946" cy="675349"/>
            <a:chOff x="874572" y="438713"/>
            <a:chExt cx="1417946" cy="724362"/>
          </a:xfrm>
        </p:grpSpPr>
        <p:grpSp>
          <p:nvGrpSpPr>
            <p:cNvPr id="2" name="그룹 1">
              <a:extLst>
                <a:ext uri="{FF2B5EF4-FFF2-40B4-BE49-F238E27FC236}">
                  <a16:creationId xmlns:a16="http://schemas.microsoft.com/office/drawing/2014/main" id="{34F090AC-D946-3CD3-4EF0-50E096568E51}"/>
                </a:ext>
              </a:extLst>
            </p:cNvPr>
            <p:cNvGrpSpPr/>
            <p:nvPr/>
          </p:nvGrpSpPr>
          <p:grpSpPr>
            <a:xfrm>
              <a:off x="897534" y="438713"/>
              <a:ext cx="1394984" cy="724362"/>
              <a:chOff x="2940351" y="1609872"/>
              <a:chExt cx="4461558" cy="1717676"/>
            </a:xfrm>
            <a:gradFill>
              <a:gsLst>
                <a:gs pos="86000">
                  <a:srgbClr val="FFFF99"/>
                </a:gs>
                <a:gs pos="100000">
                  <a:schemeClr val="bg1"/>
                </a:gs>
                <a:gs pos="27000">
                  <a:srgbClr val="FF3300"/>
                </a:gs>
              </a:gsLst>
              <a:lin ang="10800000" scaled="1"/>
            </a:gradFill>
          </p:grpSpPr>
          <p:grpSp>
            <p:nvGrpSpPr>
              <p:cNvPr id="3" name="그룹 2">
                <a:extLst>
                  <a:ext uri="{FF2B5EF4-FFF2-40B4-BE49-F238E27FC236}">
                    <a16:creationId xmlns:a16="http://schemas.microsoft.com/office/drawing/2014/main" id="{5ED8D67D-7D12-C0A3-C4DF-69DBF7D0D65D}"/>
                  </a:ext>
                </a:extLst>
              </p:cNvPr>
              <p:cNvGrpSpPr/>
              <p:nvPr/>
            </p:nvGrpSpPr>
            <p:grpSpPr>
              <a:xfrm rot="16200000">
                <a:off x="3929145" y="944275"/>
                <a:ext cx="1064286" cy="3041874"/>
                <a:chOff x="4461933" y="2863999"/>
                <a:chExt cx="536840" cy="1964266"/>
              </a:xfrm>
              <a:grpFill/>
            </p:grpSpPr>
            <p:sp>
              <p:nvSpPr>
                <p:cNvPr id="9" name="직사각형 62">
                  <a:extLst>
                    <a:ext uri="{FF2B5EF4-FFF2-40B4-BE49-F238E27FC236}">
                      <a16:creationId xmlns:a16="http://schemas.microsoft.com/office/drawing/2014/main" id="{D20938DC-02E8-EB65-743A-0C43B9D55709}"/>
                    </a:ext>
                  </a:extLst>
                </p:cNvPr>
                <p:cNvSpPr/>
                <p:nvPr/>
              </p:nvSpPr>
              <p:spPr>
                <a:xfrm>
                  <a:off x="4461933" y="2863999"/>
                  <a:ext cx="347134" cy="1964266"/>
                </a:xfrm>
                <a:custGeom>
                  <a:avLst/>
                  <a:gdLst>
                    <a:gd name="connsiteX0" fmla="*/ 0 w 237067"/>
                    <a:gd name="connsiteY0" fmla="*/ 0 h 1964266"/>
                    <a:gd name="connsiteX1" fmla="*/ 237067 w 237067"/>
                    <a:gd name="connsiteY1" fmla="*/ 0 h 1964266"/>
                    <a:gd name="connsiteX2" fmla="*/ 237067 w 237067"/>
                    <a:gd name="connsiteY2" fmla="*/ 1964266 h 1964266"/>
                    <a:gd name="connsiteX3" fmla="*/ 0 w 237067"/>
                    <a:gd name="connsiteY3" fmla="*/ 1964266 h 1964266"/>
                    <a:gd name="connsiteX4" fmla="*/ 0 w 237067"/>
                    <a:gd name="connsiteY4" fmla="*/ 0 h 1964266"/>
                    <a:gd name="connsiteX0" fmla="*/ 110067 w 347134"/>
                    <a:gd name="connsiteY0" fmla="*/ 0 h 1964266"/>
                    <a:gd name="connsiteX1" fmla="*/ 347134 w 347134"/>
                    <a:gd name="connsiteY1" fmla="*/ 0 h 1964266"/>
                    <a:gd name="connsiteX2" fmla="*/ 347134 w 347134"/>
                    <a:gd name="connsiteY2" fmla="*/ 1964266 h 1964266"/>
                    <a:gd name="connsiteX3" fmla="*/ 0 w 347134"/>
                    <a:gd name="connsiteY3" fmla="*/ 1960033 h 1964266"/>
                    <a:gd name="connsiteX4" fmla="*/ 110067 w 347134"/>
                    <a:gd name="connsiteY4" fmla="*/ 0 h 1964266"/>
                    <a:gd name="connsiteX0" fmla="*/ 110067 w 347134"/>
                    <a:gd name="connsiteY0" fmla="*/ 0 h 1964266"/>
                    <a:gd name="connsiteX1" fmla="*/ 347134 w 347134"/>
                    <a:gd name="connsiteY1" fmla="*/ 0 h 1964266"/>
                    <a:gd name="connsiteX2" fmla="*/ 347134 w 347134"/>
                    <a:gd name="connsiteY2" fmla="*/ 1964266 h 1964266"/>
                    <a:gd name="connsiteX3" fmla="*/ 0 w 347134"/>
                    <a:gd name="connsiteY3" fmla="*/ 1960033 h 1964266"/>
                    <a:gd name="connsiteX4" fmla="*/ 110067 w 347134"/>
                    <a:gd name="connsiteY4" fmla="*/ 0 h 1964266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347134" h="1964266">
                      <a:moveTo>
                        <a:pt x="110067" y="0"/>
                      </a:moveTo>
                      <a:lnTo>
                        <a:pt x="347134" y="0"/>
                      </a:lnTo>
                      <a:lnTo>
                        <a:pt x="347134" y="1964266"/>
                      </a:lnTo>
                      <a:lnTo>
                        <a:pt x="0" y="1960033"/>
                      </a:lnTo>
                      <a:cubicBezTo>
                        <a:pt x="95956" y="1687689"/>
                        <a:pt x="73378" y="653344"/>
                        <a:pt x="110067" y="0"/>
                      </a:cubicBezTo>
                      <a:close/>
                    </a:path>
                  </a:pathLst>
                </a:custGeom>
                <a:grpFill/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" name="직사각형 62">
                  <a:extLst>
                    <a:ext uri="{FF2B5EF4-FFF2-40B4-BE49-F238E27FC236}">
                      <a16:creationId xmlns:a16="http://schemas.microsoft.com/office/drawing/2014/main" id="{7652E946-D50F-CB12-FDD8-B46C9843B709}"/>
                    </a:ext>
                  </a:extLst>
                </p:cNvPr>
                <p:cNvSpPr/>
                <p:nvPr/>
              </p:nvSpPr>
              <p:spPr>
                <a:xfrm flipH="1">
                  <a:off x="4651639" y="2863999"/>
                  <a:ext cx="347134" cy="1964266"/>
                </a:xfrm>
                <a:custGeom>
                  <a:avLst/>
                  <a:gdLst>
                    <a:gd name="connsiteX0" fmla="*/ 0 w 237067"/>
                    <a:gd name="connsiteY0" fmla="*/ 0 h 1964266"/>
                    <a:gd name="connsiteX1" fmla="*/ 237067 w 237067"/>
                    <a:gd name="connsiteY1" fmla="*/ 0 h 1964266"/>
                    <a:gd name="connsiteX2" fmla="*/ 237067 w 237067"/>
                    <a:gd name="connsiteY2" fmla="*/ 1964266 h 1964266"/>
                    <a:gd name="connsiteX3" fmla="*/ 0 w 237067"/>
                    <a:gd name="connsiteY3" fmla="*/ 1964266 h 1964266"/>
                    <a:gd name="connsiteX4" fmla="*/ 0 w 237067"/>
                    <a:gd name="connsiteY4" fmla="*/ 0 h 1964266"/>
                    <a:gd name="connsiteX0" fmla="*/ 110067 w 347134"/>
                    <a:gd name="connsiteY0" fmla="*/ 0 h 1964266"/>
                    <a:gd name="connsiteX1" fmla="*/ 347134 w 347134"/>
                    <a:gd name="connsiteY1" fmla="*/ 0 h 1964266"/>
                    <a:gd name="connsiteX2" fmla="*/ 347134 w 347134"/>
                    <a:gd name="connsiteY2" fmla="*/ 1964266 h 1964266"/>
                    <a:gd name="connsiteX3" fmla="*/ 0 w 347134"/>
                    <a:gd name="connsiteY3" fmla="*/ 1960033 h 1964266"/>
                    <a:gd name="connsiteX4" fmla="*/ 110067 w 347134"/>
                    <a:gd name="connsiteY4" fmla="*/ 0 h 1964266"/>
                    <a:gd name="connsiteX0" fmla="*/ 110067 w 347134"/>
                    <a:gd name="connsiteY0" fmla="*/ 0 h 1964266"/>
                    <a:gd name="connsiteX1" fmla="*/ 347134 w 347134"/>
                    <a:gd name="connsiteY1" fmla="*/ 0 h 1964266"/>
                    <a:gd name="connsiteX2" fmla="*/ 347134 w 347134"/>
                    <a:gd name="connsiteY2" fmla="*/ 1964266 h 1964266"/>
                    <a:gd name="connsiteX3" fmla="*/ 0 w 347134"/>
                    <a:gd name="connsiteY3" fmla="*/ 1960033 h 1964266"/>
                    <a:gd name="connsiteX4" fmla="*/ 110067 w 347134"/>
                    <a:gd name="connsiteY4" fmla="*/ 0 h 1964266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347134" h="1964266">
                      <a:moveTo>
                        <a:pt x="110067" y="0"/>
                      </a:moveTo>
                      <a:lnTo>
                        <a:pt x="347134" y="0"/>
                      </a:lnTo>
                      <a:lnTo>
                        <a:pt x="347134" y="1964266"/>
                      </a:lnTo>
                      <a:lnTo>
                        <a:pt x="0" y="1960033"/>
                      </a:lnTo>
                      <a:cubicBezTo>
                        <a:pt x="95956" y="1687689"/>
                        <a:pt x="73378" y="653344"/>
                        <a:pt x="110067" y="0"/>
                      </a:cubicBezTo>
                      <a:close/>
                    </a:path>
                  </a:pathLst>
                </a:custGeom>
                <a:grpFill/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" name="이등변 삼각형 3">
                <a:extLst>
                  <a:ext uri="{FF2B5EF4-FFF2-40B4-BE49-F238E27FC236}">
                    <a16:creationId xmlns:a16="http://schemas.microsoft.com/office/drawing/2014/main" id="{278A7E18-72C2-B65C-B766-F6CB34CFFB51}"/>
                  </a:ext>
                </a:extLst>
              </p:cNvPr>
              <p:cNvSpPr/>
              <p:nvPr/>
            </p:nvSpPr>
            <p:spPr>
              <a:xfrm rot="5400000">
                <a:off x="5808506" y="1734145"/>
                <a:ext cx="1717676" cy="1469130"/>
              </a:xfrm>
              <a:prstGeom prst="triangle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더하기 기호 7">
                <a:extLst>
                  <a:ext uri="{FF2B5EF4-FFF2-40B4-BE49-F238E27FC236}">
                    <a16:creationId xmlns:a16="http://schemas.microsoft.com/office/drawing/2014/main" id="{A05CAF6F-CCCF-48E7-B55C-CD894BE8ED30}"/>
                  </a:ext>
                </a:extLst>
              </p:cNvPr>
              <p:cNvSpPr/>
              <p:nvPr/>
            </p:nvSpPr>
            <p:spPr>
              <a:xfrm>
                <a:off x="3489648" y="2325537"/>
                <a:ext cx="143104" cy="143104"/>
              </a:xfrm>
              <a:prstGeom prst="mathPlus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4" name="그룹 53">
              <a:extLst>
                <a:ext uri="{FF2B5EF4-FFF2-40B4-BE49-F238E27FC236}">
                  <a16:creationId xmlns:a16="http://schemas.microsoft.com/office/drawing/2014/main" id="{4771B00F-4DB0-91D7-1822-814E37A77FC5}"/>
                </a:ext>
              </a:extLst>
            </p:cNvPr>
            <p:cNvGrpSpPr/>
            <p:nvPr/>
          </p:nvGrpSpPr>
          <p:grpSpPr>
            <a:xfrm>
              <a:off x="874572" y="623949"/>
              <a:ext cx="526423" cy="369527"/>
              <a:chOff x="874572" y="631024"/>
              <a:chExt cx="526423" cy="369527"/>
            </a:xfrm>
          </p:grpSpPr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CD0C9C68-84E0-5692-DD48-1F8C197FAA9F}"/>
                  </a:ext>
                </a:extLst>
              </p:cNvPr>
              <p:cNvSpPr txBox="1"/>
              <p:nvPr/>
            </p:nvSpPr>
            <p:spPr>
              <a:xfrm>
                <a:off x="874572" y="631024"/>
                <a:ext cx="526423" cy="16505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400" b="1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ermentation</a:t>
                </a:r>
                <a:endParaRPr lang="ko-KR" altLang="en-US" sz="400" b="1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더하기 기호 40">
                <a:extLst>
                  <a:ext uri="{FF2B5EF4-FFF2-40B4-BE49-F238E27FC236}">
                    <a16:creationId xmlns:a16="http://schemas.microsoft.com/office/drawing/2014/main" id="{1C83BD70-EE49-97BA-FCAC-A38E000382F4}"/>
                  </a:ext>
                </a:extLst>
              </p:cNvPr>
              <p:cNvSpPr/>
              <p:nvPr/>
            </p:nvSpPr>
            <p:spPr>
              <a:xfrm>
                <a:off x="1114924" y="761456"/>
                <a:ext cx="45719" cy="45719"/>
              </a:xfrm>
              <a:prstGeom prst="mathPlus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5F83CD78-F73B-6663-52C7-4938173AE343}"/>
                  </a:ext>
                </a:extLst>
              </p:cNvPr>
              <p:cNvSpPr txBox="1"/>
              <p:nvPr/>
            </p:nvSpPr>
            <p:spPr>
              <a:xfrm>
                <a:off x="900378" y="769471"/>
                <a:ext cx="474810" cy="2310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400" b="1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mmercial</a:t>
                </a:r>
                <a:r>
                  <a:rPr lang="ko-KR" altLang="en-US" sz="400" b="1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ko-KR" sz="400" b="1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ellulase</a:t>
                </a:r>
                <a:endParaRPr lang="ko-KR" altLang="en-US" sz="400" b="1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7E123A14-5B14-927A-1690-4C706EEB9BB9}"/>
                </a:ext>
              </a:extLst>
            </p:cNvPr>
            <p:cNvSpPr txBox="1"/>
            <p:nvPr/>
          </p:nvSpPr>
          <p:spPr>
            <a:xfrm>
              <a:off x="1492333" y="648145"/>
              <a:ext cx="683351" cy="3301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Synergistic conversion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FD2BCB91-5ED6-AF26-56CE-B04D2F753E3E}"/>
              </a:ext>
            </a:extLst>
          </p:cNvPr>
          <p:cNvSpPr txBox="1"/>
          <p:nvPr/>
        </p:nvSpPr>
        <p:spPr>
          <a:xfrm>
            <a:off x="1606151" y="977206"/>
            <a:ext cx="1271502" cy="5909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400" b="1">
                <a:solidFill>
                  <a:srgbClr val="FF0000"/>
                </a:solidFill>
              </a:rPr>
              <a:t>Synergistic </a:t>
            </a:r>
            <a:r>
              <a:rPr lang="en-US" altLang="ko-KR" sz="400" b="1" dirty="0">
                <a:solidFill>
                  <a:srgbClr val="FF0000"/>
                </a:solidFill>
              </a:rPr>
              <a:t>conversion</a:t>
            </a:r>
          </a:p>
          <a:p>
            <a:br>
              <a:rPr lang="en-US" altLang="ko-KR" sz="400" b="1">
                <a:solidFill>
                  <a:srgbClr val="FF0000"/>
                </a:solidFill>
              </a:rPr>
            </a:br>
            <a:endParaRPr lang="en-US" altLang="ko-KR" sz="400" b="1" dirty="0">
              <a:solidFill>
                <a:srgbClr val="FF0000"/>
              </a:solidFill>
            </a:endParaRPr>
          </a:p>
          <a:p>
            <a:endParaRPr lang="en-US" altLang="ko-KR" sz="400" b="1" dirty="0">
              <a:solidFill>
                <a:srgbClr val="FF0000"/>
              </a:solidFill>
            </a:endParaRPr>
          </a:p>
          <a:p>
            <a:endParaRPr lang="en-US" altLang="ko-KR" sz="400" b="1" dirty="0">
              <a:solidFill>
                <a:srgbClr val="FF0000"/>
              </a:solidFill>
            </a:endParaRPr>
          </a:p>
          <a:p>
            <a:pPr>
              <a:lnSpc>
                <a:spcPct val="80000"/>
              </a:lnSpc>
            </a:pPr>
            <a:r>
              <a:rPr lang="en-US" altLang="ko-KR" sz="400" b="1" dirty="0">
                <a:solidFill>
                  <a:srgbClr val="7030A0"/>
                </a:solidFill>
              </a:rPr>
              <a:t>Enzymatic conversion with fermentation broth</a:t>
            </a:r>
          </a:p>
          <a:p>
            <a:pPr>
              <a:lnSpc>
                <a:spcPct val="80000"/>
              </a:lnSpc>
            </a:pPr>
            <a:r>
              <a:rPr lang="en-US" altLang="ko-KR" sz="400" b="1" dirty="0">
                <a:solidFill>
                  <a:srgbClr val="00B050"/>
                </a:solidFill>
              </a:rPr>
              <a:t>Enzyme conversion</a:t>
            </a:r>
          </a:p>
          <a:p>
            <a:endParaRPr lang="en-US" altLang="ko-KR" sz="200" b="1" dirty="0">
              <a:solidFill>
                <a:srgbClr val="7030A0"/>
              </a:solidFill>
            </a:endParaRPr>
          </a:p>
          <a:p>
            <a:r>
              <a:rPr lang="en-US" altLang="ko-KR" sz="400" b="1" dirty="0">
                <a:solidFill>
                  <a:srgbClr val="0000FF"/>
                </a:solidFill>
              </a:rPr>
              <a:t>Fermentation</a:t>
            </a:r>
            <a:endParaRPr lang="ko-KR" altLang="en-US" sz="400" b="1" dirty="0">
              <a:solidFill>
                <a:srgbClr val="0000FF"/>
              </a:solidFill>
            </a:endParaRPr>
          </a:p>
        </p:txBody>
      </p:sp>
      <p:sp>
        <p:nvSpPr>
          <p:cNvPr id="21" name="화살표: 오른쪽 20">
            <a:extLst>
              <a:ext uri="{FF2B5EF4-FFF2-40B4-BE49-F238E27FC236}">
                <a16:creationId xmlns:a16="http://schemas.microsoft.com/office/drawing/2014/main" id="{BFA5CF87-07E9-3FCD-A481-9ECF73BDEB9B}"/>
              </a:ext>
            </a:extLst>
          </p:cNvPr>
          <p:cNvSpPr/>
          <p:nvPr/>
        </p:nvSpPr>
        <p:spPr>
          <a:xfrm rot="1257717">
            <a:off x="415174" y="1111797"/>
            <a:ext cx="492597" cy="127656"/>
          </a:xfrm>
          <a:custGeom>
            <a:avLst/>
            <a:gdLst>
              <a:gd name="connsiteX0" fmla="*/ 0 w 861900"/>
              <a:gd name="connsiteY0" fmla="*/ 55800 h 223200"/>
              <a:gd name="connsiteX1" fmla="*/ 750300 w 861900"/>
              <a:gd name="connsiteY1" fmla="*/ 55800 h 223200"/>
              <a:gd name="connsiteX2" fmla="*/ 750300 w 861900"/>
              <a:gd name="connsiteY2" fmla="*/ 0 h 223200"/>
              <a:gd name="connsiteX3" fmla="*/ 861900 w 861900"/>
              <a:gd name="connsiteY3" fmla="*/ 111600 h 223200"/>
              <a:gd name="connsiteX4" fmla="*/ 750300 w 861900"/>
              <a:gd name="connsiteY4" fmla="*/ 223200 h 223200"/>
              <a:gd name="connsiteX5" fmla="*/ 750300 w 861900"/>
              <a:gd name="connsiteY5" fmla="*/ 167400 h 223200"/>
              <a:gd name="connsiteX6" fmla="*/ 0 w 861900"/>
              <a:gd name="connsiteY6" fmla="*/ 167400 h 223200"/>
              <a:gd name="connsiteX7" fmla="*/ 0 w 861900"/>
              <a:gd name="connsiteY7" fmla="*/ 55800 h 223200"/>
              <a:gd name="connsiteX0" fmla="*/ 0 w 861900"/>
              <a:gd name="connsiteY0" fmla="*/ 167400 h 223200"/>
              <a:gd name="connsiteX1" fmla="*/ 750300 w 861900"/>
              <a:gd name="connsiteY1" fmla="*/ 55800 h 223200"/>
              <a:gd name="connsiteX2" fmla="*/ 750300 w 861900"/>
              <a:gd name="connsiteY2" fmla="*/ 0 h 223200"/>
              <a:gd name="connsiteX3" fmla="*/ 861900 w 861900"/>
              <a:gd name="connsiteY3" fmla="*/ 111600 h 223200"/>
              <a:gd name="connsiteX4" fmla="*/ 750300 w 861900"/>
              <a:gd name="connsiteY4" fmla="*/ 223200 h 223200"/>
              <a:gd name="connsiteX5" fmla="*/ 750300 w 861900"/>
              <a:gd name="connsiteY5" fmla="*/ 167400 h 223200"/>
              <a:gd name="connsiteX6" fmla="*/ 0 w 861900"/>
              <a:gd name="connsiteY6" fmla="*/ 167400 h 223200"/>
              <a:gd name="connsiteX0" fmla="*/ 0 w 873013"/>
              <a:gd name="connsiteY0" fmla="*/ 2300 h 223200"/>
              <a:gd name="connsiteX1" fmla="*/ 761413 w 873013"/>
              <a:gd name="connsiteY1" fmla="*/ 55800 h 223200"/>
              <a:gd name="connsiteX2" fmla="*/ 761413 w 873013"/>
              <a:gd name="connsiteY2" fmla="*/ 0 h 223200"/>
              <a:gd name="connsiteX3" fmla="*/ 873013 w 873013"/>
              <a:gd name="connsiteY3" fmla="*/ 111600 h 223200"/>
              <a:gd name="connsiteX4" fmla="*/ 761413 w 873013"/>
              <a:gd name="connsiteY4" fmla="*/ 223200 h 223200"/>
              <a:gd name="connsiteX5" fmla="*/ 761413 w 873013"/>
              <a:gd name="connsiteY5" fmla="*/ 167400 h 223200"/>
              <a:gd name="connsiteX6" fmla="*/ 0 w 873013"/>
              <a:gd name="connsiteY6" fmla="*/ 2300 h 223200"/>
              <a:gd name="connsiteX0" fmla="*/ 0 w 860313"/>
              <a:gd name="connsiteY0" fmla="*/ 92787 h 223200"/>
              <a:gd name="connsiteX1" fmla="*/ 748713 w 860313"/>
              <a:gd name="connsiteY1" fmla="*/ 55800 h 223200"/>
              <a:gd name="connsiteX2" fmla="*/ 748713 w 860313"/>
              <a:gd name="connsiteY2" fmla="*/ 0 h 223200"/>
              <a:gd name="connsiteX3" fmla="*/ 860313 w 860313"/>
              <a:gd name="connsiteY3" fmla="*/ 111600 h 223200"/>
              <a:gd name="connsiteX4" fmla="*/ 748713 w 860313"/>
              <a:gd name="connsiteY4" fmla="*/ 223200 h 223200"/>
              <a:gd name="connsiteX5" fmla="*/ 748713 w 860313"/>
              <a:gd name="connsiteY5" fmla="*/ 167400 h 223200"/>
              <a:gd name="connsiteX6" fmla="*/ 0 w 860313"/>
              <a:gd name="connsiteY6" fmla="*/ 92787 h 223200"/>
              <a:gd name="connsiteX0" fmla="*/ 0 w 858725"/>
              <a:gd name="connsiteY0" fmla="*/ 111837 h 223200"/>
              <a:gd name="connsiteX1" fmla="*/ 747125 w 858725"/>
              <a:gd name="connsiteY1" fmla="*/ 55800 h 223200"/>
              <a:gd name="connsiteX2" fmla="*/ 747125 w 858725"/>
              <a:gd name="connsiteY2" fmla="*/ 0 h 223200"/>
              <a:gd name="connsiteX3" fmla="*/ 858725 w 858725"/>
              <a:gd name="connsiteY3" fmla="*/ 111600 h 223200"/>
              <a:gd name="connsiteX4" fmla="*/ 747125 w 858725"/>
              <a:gd name="connsiteY4" fmla="*/ 223200 h 223200"/>
              <a:gd name="connsiteX5" fmla="*/ 747125 w 858725"/>
              <a:gd name="connsiteY5" fmla="*/ 167400 h 223200"/>
              <a:gd name="connsiteX6" fmla="*/ 0 w 858725"/>
              <a:gd name="connsiteY6" fmla="*/ 111837 h 2232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858725" h="223200">
                <a:moveTo>
                  <a:pt x="0" y="111837"/>
                </a:moveTo>
                <a:lnTo>
                  <a:pt x="747125" y="55800"/>
                </a:lnTo>
                <a:lnTo>
                  <a:pt x="747125" y="0"/>
                </a:lnTo>
                <a:lnTo>
                  <a:pt x="858725" y="111600"/>
                </a:lnTo>
                <a:lnTo>
                  <a:pt x="747125" y="223200"/>
                </a:lnTo>
                <a:lnTo>
                  <a:pt x="747125" y="167400"/>
                </a:lnTo>
                <a:lnTo>
                  <a:pt x="0" y="111837"/>
                </a:lnTo>
                <a:close/>
              </a:path>
            </a:pathLst>
          </a:custGeom>
          <a:solidFill>
            <a:srgbClr val="FFC000">
              <a:alpha val="50196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18" name="그림 17" descr="라인, 도표, 스크린샷, 그래프이(가) 표시된 사진&#10;&#10;자동 생성된 설명">
            <a:extLst>
              <a:ext uri="{FF2B5EF4-FFF2-40B4-BE49-F238E27FC236}">
                <a16:creationId xmlns:a16="http://schemas.microsoft.com/office/drawing/2014/main" id="{538C2435-4875-9285-4FA8-D81C459B12E3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629" r="3271"/>
          <a:stretch/>
        </p:blipFill>
        <p:spPr>
          <a:xfrm>
            <a:off x="916780" y="917688"/>
            <a:ext cx="776451" cy="6585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727577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테마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31</TotalTime>
  <Words>30</Words>
  <Application>Microsoft Office PowerPoint</Application>
  <PresentationFormat>사용자 지정</PresentationFormat>
  <Paragraphs>19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ptos</vt:lpstr>
      <vt:lpstr>Aptos Display</vt:lpstr>
      <vt:lpstr>Arial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이용인</dc:creator>
  <cp:lastModifiedBy>이용인</cp:lastModifiedBy>
  <cp:revision>5</cp:revision>
  <cp:lastPrinted>2024-10-29T11:05:38Z</cp:lastPrinted>
  <dcterms:created xsi:type="dcterms:W3CDTF">2024-10-29T06:02:19Z</dcterms:created>
  <dcterms:modified xsi:type="dcterms:W3CDTF">2024-11-27T01:01:21Z</dcterms:modified>
</cp:coreProperties>
</file>